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9" r:id="rId6"/>
    <p:sldId id="261" r:id="rId7"/>
    <p:sldId id="262" r:id="rId8"/>
    <p:sldId id="263" r:id="rId9"/>
    <p:sldId id="264" r:id="rId10"/>
    <p:sldId id="257" r:id="rId11"/>
    <p:sldId id="258" r:id="rId12"/>
    <p:sldId id="265" r:id="rId1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635" autoAdjust="0"/>
    <p:restoredTop sz="94660"/>
  </p:normalViewPr>
  <p:slideViewPr>
    <p:cSldViewPr snapToGrid="0">
      <p:cViewPr varScale="1">
        <p:scale>
          <a:sx n="72" d="100"/>
          <a:sy n="72" d="100"/>
        </p:scale>
        <p:origin x="136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ente\Desktop\nuovi%20articoli\articolo%20bret%20valentina\ANALISI%20VARIANZA%20JM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ente\Desktop\nuovi%20articoli\articolo%20bret%20valentina\ANALISI%20VARIANZA%20JM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tente\Desktop\nuovi%20articoli\articolo%20bret%20valentina\ANALISI%20VARIANZA%20JMP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dirty="0" err="1"/>
              <a:t>Ethanol</a:t>
            </a:r>
            <a:r>
              <a:rPr lang="it-IT" baseline="0" dirty="0"/>
              <a:t> %v/v</a:t>
            </a:r>
            <a:endParaRPr lang="it-IT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M$239</c:f>
              <c:strCache>
                <c:ptCount val="1"/>
                <c:pt idx="0">
                  <c:v>ETANOLO TEORIC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7E9-4B43-A6D4-4A8C3CDC1520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7E9-4B43-A6D4-4A8C3CDC1520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7E9-4B43-A6D4-4A8C3CDC1520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7E9-4B43-A6D4-4A8C3CDC1520}"/>
              </c:ext>
            </c:extLst>
          </c:dPt>
          <c:dPt>
            <c:idx val="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17E9-4B43-A6D4-4A8C3CDC1520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17E9-4B43-A6D4-4A8C3CDC1520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17E9-4B43-A6D4-4A8C3CDC1520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17E9-4B43-A6D4-4A8C3CDC1520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17E9-4B43-A6D4-4A8C3CDC1520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17E9-4B43-A6D4-4A8C3CDC1520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17E9-4B43-A6D4-4A8C3CDC1520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17E9-4B43-A6D4-4A8C3CDC1520}"/>
              </c:ext>
            </c:extLst>
          </c:dPt>
          <c:dPt>
            <c:idx val="1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17E9-4B43-A6D4-4A8C3CDC1520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17E9-4B43-A6D4-4A8C3CDC1520}"/>
              </c:ext>
            </c:extLst>
          </c:dPt>
          <c:dPt>
            <c:idx val="1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17E9-4B43-A6D4-4A8C3CDC1520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17E9-4B43-A6D4-4A8C3CDC1520}"/>
              </c:ext>
            </c:extLst>
          </c:dPt>
          <c:dPt>
            <c:idx val="1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17E9-4B43-A6D4-4A8C3CDC1520}"/>
              </c:ext>
            </c:extLst>
          </c:dPt>
          <c:dPt>
            <c:idx val="1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17E9-4B43-A6D4-4A8C3CDC1520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17E9-4B43-A6D4-4A8C3CDC1520}"/>
              </c:ext>
            </c:extLst>
          </c:dPt>
          <c:dPt>
            <c:idx val="1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17E9-4B43-A6D4-4A8C3CDC1520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17E9-4B43-A6D4-4A8C3CDC1520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17E9-4B43-A6D4-4A8C3CDC1520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17E9-4B43-A6D4-4A8C3CDC1520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17E9-4B43-A6D4-4A8C3CDC1520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17E9-4B43-A6D4-4A8C3CDC1520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17E9-4B43-A6D4-4A8C3CDC1520}"/>
              </c:ext>
            </c:extLst>
          </c:dPt>
          <c:dPt>
            <c:idx val="26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17E9-4B43-A6D4-4A8C3CDC1520}"/>
              </c:ext>
            </c:extLst>
          </c:dPt>
          <c:dPt>
            <c:idx val="27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17E9-4B43-A6D4-4A8C3CDC1520}"/>
              </c:ext>
            </c:extLst>
          </c:dPt>
          <c:dPt>
            <c:idx val="28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17E9-4B43-A6D4-4A8C3CDC1520}"/>
              </c:ext>
            </c:extLst>
          </c:dPt>
          <c:dPt>
            <c:idx val="29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17E9-4B43-A6D4-4A8C3CDC1520}"/>
              </c:ext>
            </c:extLst>
          </c:dPt>
          <c:dPt>
            <c:idx val="3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17E9-4B43-A6D4-4A8C3CDC1520}"/>
              </c:ext>
            </c:extLst>
          </c:dPt>
          <c:dPt>
            <c:idx val="31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F-17E9-4B43-A6D4-4A8C3CDC1520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1-17E9-4B43-A6D4-4A8C3CDC1520}"/>
              </c:ext>
            </c:extLst>
          </c:dPt>
          <c:dPt>
            <c:idx val="3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3-17E9-4B43-A6D4-4A8C3CDC1520}"/>
              </c:ext>
            </c:extLst>
          </c:dPt>
          <c:dPt>
            <c:idx val="36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5-17E9-4B43-A6D4-4A8C3CDC1520}"/>
              </c:ext>
            </c:extLst>
          </c:dPt>
          <c:dPt>
            <c:idx val="37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7-17E9-4B43-A6D4-4A8C3CDC1520}"/>
              </c:ext>
            </c:extLst>
          </c:dPt>
          <c:dPt>
            <c:idx val="38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9-17E9-4B43-A6D4-4A8C3CDC1520}"/>
              </c:ext>
            </c:extLst>
          </c:dPt>
          <c:dPt>
            <c:idx val="39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B-17E9-4B43-A6D4-4A8C3CDC1520}"/>
              </c:ext>
            </c:extLst>
          </c:dPt>
          <c:dPt>
            <c:idx val="40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D-17E9-4B43-A6D4-4A8C3CDC1520}"/>
              </c:ext>
            </c:extLst>
          </c:dPt>
          <c:dPt>
            <c:idx val="41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F-17E9-4B43-A6D4-4A8C3CDC1520}"/>
              </c:ext>
            </c:extLst>
          </c:dPt>
          <c:dPt>
            <c:idx val="4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1-17E9-4B43-A6D4-4A8C3CDC1520}"/>
              </c:ext>
            </c:extLst>
          </c:dPt>
          <c:dPt>
            <c:idx val="43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3-17E9-4B43-A6D4-4A8C3CDC1520}"/>
              </c:ext>
            </c:extLst>
          </c:dPt>
          <c:errBars>
            <c:errBarType val="both"/>
            <c:errValType val="cust"/>
            <c:noEndCap val="0"/>
            <c:plus>
              <c:numRef>
                <c:f>Foglio1!$M$144:$M$187</c:f>
                <c:numCache>
                  <c:formatCode>General</c:formatCode>
                  <c:ptCount val="44"/>
                  <c:pt idx="0">
                    <c:v>0.31466251762801384</c:v>
                  </c:pt>
                  <c:pt idx="1">
                    <c:v>0.62932503525602645</c:v>
                  </c:pt>
                  <c:pt idx="2">
                    <c:v>1.9374725804510211E-2</c:v>
                  </c:pt>
                  <c:pt idx="3">
                    <c:v>8.0044487630303973E-2</c:v>
                  </c:pt>
                  <c:pt idx="4">
                    <c:v>0.20138401128191535</c:v>
                  </c:pt>
                  <c:pt idx="5">
                    <c:v>0</c:v>
                  </c:pt>
                  <c:pt idx="6">
                    <c:v>2.3900209204104874E-2</c:v>
                  </c:pt>
                  <c:pt idx="7">
                    <c:v>0.13392602435674625</c:v>
                  </c:pt>
                  <c:pt idx="8">
                    <c:v>0.70876808383751144</c:v>
                  </c:pt>
                  <c:pt idx="9">
                    <c:v>0.70876808383751144</c:v>
                  </c:pt>
                  <c:pt idx="10">
                    <c:v>0</c:v>
                  </c:pt>
                  <c:pt idx="11">
                    <c:v>0.44052752467921863</c:v>
                  </c:pt>
                  <c:pt idx="12">
                    <c:v>1.1453715641659694</c:v>
                  </c:pt>
                  <c:pt idx="13">
                    <c:v>0</c:v>
                  </c:pt>
                  <c:pt idx="14">
                    <c:v>0.73001704089699859</c:v>
                  </c:pt>
                  <c:pt idx="15">
                    <c:v>0.78036304371751286</c:v>
                  </c:pt>
                  <c:pt idx="16">
                    <c:v>0</c:v>
                  </c:pt>
                  <c:pt idx="17">
                    <c:v>1.6865910944861531</c:v>
                  </c:pt>
                  <c:pt idx="18">
                    <c:v>0</c:v>
                  </c:pt>
                  <c:pt idx="19">
                    <c:v>0.34436100243786255</c:v>
                  </c:pt>
                  <c:pt idx="20">
                    <c:v>0.67967103807653506</c:v>
                  </c:pt>
                  <c:pt idx="21">
                    <c:v>0</c:v>
                  </c:pt>
                  <c:pt idx="22">
                    <c:v>0</c:v>
                  </c:pt>
                  <c:pt idx="23">
                    <c:v>2.8445491593572321</c:v>
                  </c:pt>
                  <c:pt idx="24">
                    <c:v>0</c:v>
                  </c:pt>
                  <c:pt idx="25">
                    <c:v>0.40276802256385641</c:v>
                  </c:pt>
                  <c:pt idx="26">
                    <c:v>0.18879751057682162</c:v>
                  </c:pt>
                  <c:pt idx="27">
                    <c:v>0.50346002820479652</c:v>
                  </c:pt>
                  <c:pt idx="28">
                    <c:v>0.66708453737138806</c:v>
                  </c:pt>
                  <c:pt idx="29">
                    <c:v>0</c:v>
                  </c:pt>
                  <c:pt idx="30">
                    <c:v>0.51604652890992919</c:v>
                  </c:pt>
                  <c:pt idx="31">
                    <c:v>0.59156553314066607</c:v>
                  </c:pt>
                  <c:pt idx="32">
                    <c:v>0.35242201974337545</c:v>
                  </c:pt>
                  <c:pt idx="33">
                    <c:v>0</c:v>
                  </c:pt>
                  <c:pt idx="34">
                    <c:v>0.51958206281590325</c:v>
                  </c:pt>
                  <c:pt idx="35">
                    <c:v>0.36628131265464592</c:v>
                  </c:pt>
                  <c:pt idx="36">
                    <c:v>0.40276802256385708</c:v>
                  </c:pt>
                  <c:pt idx="37">
                    <c:v>0.2723775321130576</c:v>
                  </c:pt>
                  <c:pt idx="38">
                    <c:v>0.17041273426595771</c:v>
                  </c:pt>
                  <c:pt idx="39">
                    <c:v>0.9817470549994044</c:v>
                  </c:pt>
                  <c:pt idx="40">
                    <c:v>8.4569971029939447E-2</c:v>
                  </c:pt>
                  <c:pt idx="41">
                    <c:v>0.37660507166002583</c:v>
                  </c:pt>
                  <c:pt idx="42">
                    <c:v>0.1132785063460985</c:v>
                  </c:pt>
                  <c:pt idx="43">
                    <c:v>3.6486709909224979E-2</c:v>
                  </c:pt>
                </c:numCache>
              </c:numRef>
            </c:plus>
            <c:minus>
              <c:numRef>
                <c:f>Foglio1!$M$144:$M$187</c:f>
                <c:numCache>
                  <c:formatCode>General</c:formatCode>
                  <c:ptCount val="44"/>
                  <c:pt idx="0">
                    <c:v>0.31466251762801384</c:v>
                  </c:pt>
                  <c:pt idx="1">
                    <c:v>0.62932503525602645</c:v>
                  </c:pt>
                  <c:pt idx="2">
                    <c:v>1.9374725804510211E-2</c:v>
                  </c:pt>
                  <c:pt idx="3">
                    <c:v>8.0044487630303973E-2</c:v>
                  </c:pt>
                  <c:pt idx="4">
                    <c:v>0.20138401128191535</c:v>
                  </c:pt>
                  <c:pt idx="5">
                    <c:v>0</c:v>
                  </c:pt>
                  <c:pt idx="6">
                    <c:v>2.3900209204104874E-2</c:v>
                  </c:pt>
                  <c:pt idx="7">
                    <c:v>0.13392602435674625</c:v>
                  </c:pt>
                  <c:pt idx="8">
                    <c:v>0.70876808383751144</c:v>
                  </c:pt>
                  <c:pt idx="9">
                    <c:v>0.70876808383751144</c:v>
                  </c:pt>
                  <c:pt idx="10">
                    <c:v>0</c:v>
                  </c:pt>
                  <c:pt idx="11">
                    <c:v>0.44052752467921863</c:v>
                  </c:pt>
                  <c:pt idx="12">
                    <c:v>1.1453715641659694</c:v>
                  </c:pt>
                  <c:pt idx="13">
                    <c:v>0</c:v>
                  </c:pt>
                  <c:pt idx="14">
                    <c:v>0.73001704089699859</c:v>
                  </c:pt>
                  <c:pt idx="15">
                    <c:v>0.78036304371751286</c:v>
                  </c:pt>
                  <c:pt idx="16">
                    <c:v>0</c:v>
                  </c:pt>
                  <c:pt idx="17">
                    <c:v>1.6865910944861531</c:v>
                  </c:pt>
                  <c:pt idx="18">
                    <c:v>0</c:v>
                  </c:pt>
                  <c:pt idx="19">
                    <c:v>0.34436100243786255</c:v>
                  </c:pt>
                  <c:pt idx="20">
                    <c:v>0.67967103807653506</c:v>
                  </c:pt>
                  <c:pt idx="21">
                    <c:v>0</c:v>
                  </c:pt>
                  <c:pt idx="22">
                    <c:v>0</c:v>
                  </c:pt>
                  <c:pt idx="23">
                    <c:v>2.8445491593572321</c:v>
                  </c:pt>
                  <c:pt idx="24">
                    <c:v>0</c:v>
                  </c:pt>
                  <c:pt idx="25">
                    <c:v>0.40276802256385641</c:v>
                  </c:pt>
                  <c:pt idx="26">
                    <c:v>0.18879751057682162</c:v>
                  </c:pt>
                  <c:pt idx="27">
                    <c:v>0.50346002820479652</c:v>
                  </c:pt>
                  <c:pt idx="28">
                    <c:v>0.66708453737138806</c:v>
                  </c:pt>
                  <c:pt idx="29">
                    <c:v>0</c:v>
                  </c:pt>
                  <c:pt idx="30">
                    <c:v>0.51604652890992919</c:v>
                  </c:pt>
                  <c:pt idx="31">
                    <c:v>0.59156553314066607</c:v>
                  </c:pt>
                  <c:pt idx="32">
                    <c:v>0.35242201974337545</c:v>
                  </c:pt>
                  <c:pt idx="33">
                    <c:v>0</c:v>
                  </c:pt>
                  <c:pt idx="34">
                    <c:v>0.51958206281590325</c:v>
                  </c:pt>
                  <c:pt idx="35">
                    <c:v>0.36628131265464592</c:v>
                  </c:pt>
                  <c:pt idx="36">
                    <c:v>0.40276802256385708</c:v>
                  </c:pt>
                  <c:pt idx="37">
                    <c:v>0.2723775321130576</c:v>
                  </c:pt>
                  <c:pt idx="38">
                    <c:v>0.17041273426595771</c:v>
                  </c:pt>
                  <c:pt idx="39">
                    <c:v>0.9817470549994044</c:v>
                  </c:pt>
                  <c:pt idx="40">
                    <c:v>8.4569971029939447E-2</c:v>
                  </c:pt>
                  <c:pt idx="41">
                    <c:v>0.37660507166002583</c:v>
                  </c:pt>
                  <c:pt idx="42">
                    <c:v>0.1132785063460985</c:v>
                  </c:pt>
                  <c:pt idx="43">
                    <c:v>3.648670990922497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L$240:$L$283</c:f>
              <c:strCache>
                <c:ptCount val="44"/>
                <c:pt idx="0">
                  <c:v>gCS1a</c:v>
                </c:pt>
                <c:pt idx="1">
                  <c:v>gS4b</c:v>
                </c:pt>
                <c:pt idx="2">
                  <c:v>wF10b</c:v>
                </c:pt>
                <c:pt idx="3">
                  <c:v>gCF2a</c:v>
                </c:pt>
                <c:pt idx="4">
                  <c:v>wF5a</c:v>
                </c:pt>
                <c:pt idx="5">
                  <c:v>gCS2a</c:v>
                </c:pt>
                <c:pt idx="6">
                  <c:v>wF5c</c:v>
                </c:pt>
                <c:pt idx="7">
                  <c:v>gCS5a</c:v>
                </c:pt>
                <c:pt idx="8">
                  <c:v>wF12b</c:v>
                </c:pt>
                <c:pt idx="9">
                  <c:v>wF12c</c:v>
                </c:pt>
                <c:pt idx="10">
                  <c:v>wF7c</c:v>
                </c:pt>
                <c:pt idx="11">
                  <c:v>wV1a</c:v>
                </c:pt>
                <c:pt idx="12">
                  <c:v>gS4c</c:v>
                </c:pt>
                <c:pt idx="13">
                  <c:v>gS3a</c:v>
                </c:pt>
                <c:pt idx="14">
                  <c:v>gCS6a</c:v>
                </c:pt>
                <c:pt idx="15">
                  <c:v>wF11d</c:v>
                </c:pt>
                <c:pt idx="16">
                  <c:v>wF7a</c:v>
                </c:pt>
                <c:pt idx="17">
                  <c:v>wF5b</c:v>
                </c:pt>
                <c:pt idx="18">
                  <c:v>wF10a</c:v>
                </c:pt>
                <c:pt idx="19">
                  <c:v>106</c:v>
                </c:pt>
                <c:pt idx="20">
                  <c:v>6707</c:v>
                </c:pt>
                <c:pt idx="21">
                  <c:v>6710</c:v>
                </c:pt>
                <c:pt idx="22">
                  <c:v>C21.4</c:v>
                </c:pt>
                <c:pt idx="23">
                  <c:v>C21.6</c:v>
                </c:pt>
                <c:pt idx="24">
                  <c:v>C21.1t1</c:v>
                </c:pt>
                <c:pt idx="25">
                  <c:v>C2.3</c:v>
                </c:pt>
                <c:pt idx="26">
                  <c:v>M1.</c:v>
                </c:pt>
                <c:pt idx="27">
                  <c:v>M4.</c:v>
                </c:pt>
                <c:pt idx="28">
                  <c:v>M5.</c:v>
                </c:pt>
                <c:pt idx="29">
                  <c:v>M6.</c:v>
                </c:pt>
                <c:pt idx="30">
                  <c:v>M12.</c:v>
                </c:pt>
                <c:pt idx="31">
                  <c:v>M11.</c:v>
                </c:pt>
                <c:pt idx="32">
                  <c:v>EB1G</c:v>
                </c:pt>
                <c:pt idx="33">
                  <c:v>EB1P</c:v>
                </c:pt>
                <c:pt idx="34">
                  <c:v>G3</c:v>
                </c:pt>
                <c:pt idx="35">
                  <c:v>G9</c:v>
                </c:pt>
                <c:pt idx="36">
                  <c:v>F6</c:v>
                </c:pt>
                <c:pt idx="37">
                  <c:v>F10</c:v>
                </c:pt>
                <c:pt idx="38">
                  <c:v>F32</c:v>
                </c:pt>
                <c:pt idx="39">
                  <c:v>F43</c:v>
                </c:pt>
                <c:pt idx="40">
                  <c:v>F14</c:v>
                </c:pt>
                <c:pt idx="41">
                  <c:v>F17</c:v>
                </c:pt>
                <c:pt idx="42">
                  <c:v>F22</c:v>
                </c:pt>
                <c:pt idx="43">
                  <c:v>F38</c:v>
                </c:pt>
              </c:strCache>
            </c:strRef>
          </c:cat>
          <c:val>
            <c:numRef>
              <c:f>Foglio1!$M$240:$M$283</c:f>
              <c:numCache>
                <c:formatCode>General</c:formatCode>
                <c:ptCount val="44"/>
                <c:pt idx="0">
                  <c:v>9.4250999999999827</c:v>
                </c:pt>
                <c:pt idx="1">
                  <c:v>11.1784</c:v>
                </c:pt>
                <c:pt idx="2">
                  <c:v>10.473700000000001</c:v>
                </c:pt>
                <c:pt idx="3">
                  <c:v>9.7009999999999899</c:v>
                </c:pt>
                <c:pt idx="4">
                  <c:v>9.7009999999999899</c:v>
                </c:pt>
                <c:pt idx="5">
                  <c:v>5.3756000000000181</c:v>
                </c:pt>
                <c:pt idx="6">
                  <c:v>8.4444999999999997</c:v>
                </c:pt>
                <c:pt idx="7">
                  <c:v>3.5688999999999904</c:v>
                </c:pt>
                <c:pt idx="8">
                  <c:v>8.6063000000000081</c:v>
                </c:pt>
                <c:pt idx="9">
                  <c:v>8.6063000000000081</c:v>
                </c:pt>
                <c:pt idx="10">
                  <c:v>8.6199999999999992</c:v>
                </c:pt>
                <c:pt idx="11">
                  <c:v>8.9801000000000002</c:v>
                </c:pt>
                <c:pt idx="12">
                  <c:v>10.172699999999981</c:v>
                </c:pt>
                <c:pt idx="13">
                  <c:v>9.93</c:v>
                </c:pt>
                <c:pt idx="14">
                  <c:v>5.0196000000000094</c:v>
                </c:pt>
                <c:pt idx="15">
                  <c:v>9.6476000000000077</c:v>
                </c:pt>
                <c:pt idx="16">
                  <c:v>8.6</c:v>
                </c:pt>
                <c:pt idx="17">
                  <c:v>8.9890000000000008</c:v>
                </c:pt>
                <c:pt idx="18">
                  <c:v>8.99</c:v>
                </c:pt>
                <c:pt idx="19">
                  <c:v>8.0277999999999814</c:v>
                </c:pt>
                <c:pt idx="20">
                  <c:v>9.7455000000000105</c:v>
                </c:pt>
                <c:pt idx="21">
                  <c:v>7.3513999999999999</c:v>
                </c:pt>
                <c:pt idx="22">
                  <c:v>7.9031999999999911</c:v>
                </c:pt>
                <c:pt idx="23">
                  <c:v>8.51</c:v>
                </c:pt>
                <c:pt idx="24">
                  <c:v>6.3190000000000186</c:v>
                </c:pt>
                <c:pt idx="25">
                  <c:v>8.80210000000001</c:v>
                </c:pt>
                <c:pt idx="26">
                  <c:v>8.9890000000000185</c:v>
                </c:pt>
                <c:pt idx="27">
                  <c:v>9.5675000000000168</c:v>
                </c:pt>
                <c:pt idx="28">
                  <c:v>10.039200000000017</c:v>
                </c:pt>
                <c:pt idx="29">
                  <c:v>9.1580999999999904</c:v>
                </c:pt>
                <c:pt idx="30">
                  <c:v>8.9445000000000352</c:v>
                </c:pt>
                <c:pt idx="31">
                  <c:v>7.3869999999999827</c:v>
                </c:pt>
                <c:pt idx="32">
                  <c:v>9.11</c:v>
                </c:pt>
                <c:pt idx="33">
                  <c:v>7.4581999999999997</c:v>
                </c:pt>
                <c:pt idx="34">
                  <c:v>9.7171999999999912</c:v>
                </c:pt>
                <c:pt idx="35">
                  <c:v>6.89</c:v>
                </c:pt>
                <c:pt idx="36">
                  <c:v>7.9209999999999825</c:v>
                </c:pt>
                <c:pt idx="37">
                  <c:v>12.620200000000001</c:v>
                </c:pt>
                <c:pt idx="38">
                  <c:v>10.2067</c:v>
                </c:pt>
                <c:pt idx="39">
                  <c:v>11.747999999999966</c:v>
                </c:pt>
                <c:pt idx="40">
                  <c:v>7.6362000000000201</c:v>
                </c:pt>
                <c:pt idx="41">
                  <c:v>10.56429999999995</c:v>
                </c:pt>
                <c:pt idx="42">
                  <c:v>9.1580999999999904</c:v>
                </c:pt>
                <c:pt idx="43">
                  <c:v>11.091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4-17E9-4B43-A6D4-4A8C3CDC15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2537592"/>
        <c:axId val="672538312"/>
      </c:barChart>
      <c:catAx>
        <c:axId val="672537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2538312"/>
        <c:crosses val="autoZero"/>
        <c:auto val="1"/>
        <c:lblAlgn val="ctr"/>
        <c:lblOffset val="100"/>
        <c:noMultiLvlLbl val="0"/>
      </c:catAx>
      <c:valAx>
        <c:axId val="6725383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2537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/>
              <a:t>FERMENTATION R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3C3-4712-B86C-D8C2E717B260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3C3-4712-B86C-D8C2E717B260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3C3-4712-B86C-D8C2E717B260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3C3-4712-B86C-D8C2E717B260}"/>
              </c:ext>
            </c:extLst>
          </c:dPt>
          <c:dPt>
            <c:idx val="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13C3-4712-B86C-D8C2E717B260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13C3-4712-B86C-D8C2E717B260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13C3-4712-B86C-D8C2E717B260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13C3-4712-B86C-D8C2E717B260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13C3-4712-B86C-D8C2E717B260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13C3-4712-B86C-D8C2E717B260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13C3-4712-B86C-D8C2E717B260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13C3-4712-B86C-D8C2E717B260}"/>
              </c:ext>
            </c:extLst>
          </c:dPt>
          <c:dPt>
            <c:idx val="1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13C3-4712-B86C-D8C2E717B260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13C3-4712-B86C-D8C2E717B260}"/>
              </c:ext>
            </c:extLst>
          </c:dPt>
          <c:dPt>
            <c:idx val="1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13C3-4712-B86C-D8C2E717B260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13C3-4712-B86C-D8C2E717B260}"/>
              </c:ext>
            </c:extLst>
          </c:dPt>
          <c:dPt>
            <c:idx val="1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13C3-4712-B86C-D8C2E717B260}"/>
              </c:ext>
            </c:extLst>
          </c:dPt>
          <c:dPt>
            <c:idx val="1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13C3-4712-B86C-D8C2E717B260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13C3-4712-B86C-D8C2E717B260}"/>
              </c:ext>
            </c:extLst>
          </c:dPt>
          <c:dPt>
            <c:idx val="1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13C3-4712-B86C-D8C2E717B260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13C3-4712-B86C-D8C2E717B260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13C3-4712-B86C-D8C2E717B260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13C3-4712-B86C-D8C2E717B260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13C3-4712-B86C-D8C2E717B260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13C3-4712-B86C-D8C2E717B260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13C3-4712-B86C-D8C2E717B260}"/>
              </c:ext>
            </c:extLst>
          </c:dPt>
          <c:dPt>
            <c:idx val="26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13C3-4712-B86C-D8C2E717B260}"/>
              </c:ext>
            </c:extLst>
          </c:dPt>
          <c:dPt>
            <c:idx val="27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13C3-4712-B86C-D8C2E717B260}"/>
              </c:ext>
            </c:extLst>
          </c:dPt>
          <c:dPt>
            <c:idx val="28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13C3-4712-B86C-D8C2E717B260}"/>
              </c:ext>
            </c:extLst>
          </c:dPt>
          <c:dPt>
            <c:idx val="29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13C3-4712-B86C-D8C2E717B260}"/>
              </c:ext>
            </c:extLst>
          </c:dPt>
          <c:dPt>
            <c:idx val="3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13C3-4712-B86C-D8C2E717B260}"/>
              </c:ext>
            </c:extLst>
          </c:dPt>
          <c:dPt>
            <c:idx val="31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F-13C3-4712-B86C-D8C2E717B260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1-13C3-4712-B86C-D8C2E717B260}"/>
              </c:ext>
            </c:extLst>
          </c:dPt>
          <c:dPt>
            <c:idx val="3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3-13C3-4712-B86C-D8C2E717B260}"/>
              </c:ext>
            </c:extLst>
          </c:dPt>
          <c:dPt>
            <c:idx val="36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5-13C3-4712-B86C-D8C2E717B260}"/>
              </c:ext>
            </c:extLst>
          </c:dPt>
          <c:dPt>
            <c:idx val="37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7-13C3-4712-B86C-D8C2E717B260}"/>
              </c:ext>
            </c:extLst>
          </c:dPt>
          <c:dPt>
            <c:idx val="38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9-13C3-4712-B86C-D8C2E717B260}"/>
              </c:ext>
            </c:extLst>
          </c:dPt>
          <c:dPt>
            <c:idx val="39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B-13C3-4712-B86C-D8C2E717B260}"/>
              </c:ext>
            </c:extLst>
          </c:dPt>
          <c:dPt>
            <c:idx val="40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D-13C3-4712-B86C-D8C2E717B260}"/>
              </c:ext>
            </c:extLst>
          </c:dPt>
          <c:dPt>
            <c:idx val="41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F-13C3-4712-B86C-D8C2E717B260}"/>
              </c:ext>
            </c:extLst>
          </c:dPt>
          <c:dPt>
            <c:idx val="4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1-13C3-4712-B86C-D8C2E717B260}"/>
              </c:ext>
            </c:extLst>
          </c:dPt>
          <c:dPt>
            <c:idx val="43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3-13C3-4712-B86C-D8C2E717B260}"/>
              </c:ext>
            </c:extLst>
          </c:dPt>
          <c:errBars>
            <c:errBarType val="both"/>
            <c:errValType val="cust"/>
            <c:noEndCap val="0"/>
            <c:plus>
              <c:numRef>
                <c:f>Foglio1!$N$144:$N$187</c:f>
                <c:numCache>
                  <c:formatCode>General</c:formatCode>
                  <c:ptCount val="44"/>
                  <c:pt idx="0">
                    <c:v>3.030457633656732E-3</c:v>
                  </c:pt>
                  <c:pt idx="1">
                    <c:v>1.1111677990075628E-2</c:v>
                  </c:pt>
                  <c:pt idx="2">
                    <c:v>9.0913729009730292E-3</c:v>
                  </c:pt>
                  <c:pt idx="3">
                    <c:v>1.7172593257386362E-2</c:v>
                  </c:pt>
                  <c:pt idx="4">
                    <c:v>0</c:v>
                  </c:pt>
                  <c:pt idx="5">
                    <c:v>0</c:v>
                  </c:pt>
                  <c:pt idx="6">
                    <c:v>1.2121830534627032E-2</c:v>
                  </c:pt>
                  <c:pt idx="7">
                    <c:v>3.0304576336538536E-3</c:v>
                  </c:pt>
                  <c:pt idx="8">
                    <c:v>1.8220120447343578E-2</c:v>
                  </c:pt>
                  <c:pt idx="9">
                    <c:v>1.8220120447343578E-2</c:v>
                  </c:pt>
                  <c:pt idx="10">
                    <c:v>0</c:v>
                  </c:pt>
                  <c:pt idx="11">
                    <c:v>3.030457633656732E-3</c:v>
                  </c:pt>
                  <c:pt idx="12">
                    <c:v>0</c:v>
                  </c:pt>
                  <c:pt idx="13">
                    <c:v>0</c:v>
                  </c:pt>
                  <c:pt idx="14">
                    <c:v>5.0507627227621681E-3</c:v>
                  </c:pt>
                  <c:pt idx="15">
                    <c:v>1.7172593257389165E-2</c:v>
                  </c:pt>
                  <c:pt idx="16">
                    <c:v>0</c:v>
                  </c:pt>
                  <c:pt idx="17">
                    <c:v>1.0101525445542323E-3</c:v>
                  </c:pt>
                  <c:pt idx="18">
                    <c:v>0</c:v>
                  </c:pt>
                  <c:pt idx="19">
                    <c:v>1.8182745801940497E-2</c:v>
                  </c:pt>
                  <c:pt idx="20">
                    <c:v>1.7172593257389183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1.919289834649502E-2</c:v>
                  </c:pt>
                  <c:pt idx="24">
                    <c:v>0</c:v>
                  </c:pt>
                  <c:pt idx="25">
                    <c:v>1.4142135623729334E-2</c:v>
                  </c:pt>
                  <c:pt idx="26">
                    <c:v>8.0812203564186863E-3</c:v>
                  </c:pt>
                  <c:pt idx="27">
                    <c:v>1.9192898346492095E-2</c:v>
                  </c:pt>
                  <c:pt idx="28">
                    <c:v>2.0203050891024047E-3</c:v>
                  </c:pt>
                  <c:pt idx="29">
                    <c:v>0</c:v>
                  </c:pt>
                  <c:pt idx="30">
                    <c:v>3.0304576336566292E-3</c:v>
                  </c:pt>
                  <c:pt idx="31">
                    <c:v>6.0609152673132584E-3</c:v>
                  </c:pt>
                  <c:pt idx="32">
                    <c:v>8.2832508653282302E-2</c:v>
                  </c:pt>
                  <c:pt idx="33">
                    <c:v>0</c:v>
                  </c:pt>
                  <c:pt idx="34">
                    <c:v>9.091372900969891E-3</c:v>
                  </c:pt>
                  <c:pt idx="35">
                    <c:v>1.2121830534626522E-2</c:v>
                  </c:pt>
                  <c:pt idx="36">
                    <c:v>9.091372900970212E-3</c:v>
                  </c:pt>
                  <c:pt idx="37">
                    <c:v>1.1111677990072705E-2</c:v>
                  </c:pt>
                  <c:pt idx="38">
                    <c:v>1.0101525445521599E-2</c:v>
                  </c:pt>
                  <c:pt idx="39">
                    <c:v>8.0812203564161016E-3</c:v>
                  </c:pt>
                  <c:pt idx="40">
                    <c:v>3.1314728881115583E-2</c:v>
                  </c:pt>
                  <c:pt idx="41">
                    <c:v>1.8182745801939817E-2</c:v>
                  </c:pt>
                  <c:pt idx="42">
                    <c:v>2.020305089105427E-3</c:v>
                  </c:pt>
                  <c:pt idx="43">
                    <c:v>2.020305089105427E-3</c:v>
                  </c:pt>
                </c:numCache>
              </c:numRef>
            </c:plus>
            <c:minus>
              <c:numRef>
                <c:f>Foglio1!$N$144:$N$187</c:f>
                <c:numCache>
                  <c:formatCode>General</c:formatCode>
                  <c:ptCount val="44"/>
                  <c:pt idx="0">
                    <c:v>3.030457633656732E-3</c:v>
                  </c:pt>
                  <c:pt idx="1">
                    <c:v>1.1111677990075628E-2</c:v>
                  </c:pt>
                  <c:pt idx="2">
                    <c:v>9.0913729009730292E-3</c:v>
                  </c:pt>
                  <c:pt idx="3">
                    <c:v>1.7172593257386362E-2</c:v>
                  </c:pt>
                  <c:pt idx="4">
                    <c:v>0</c:v>
                  </c:pt>
                  <c:pt idx="5">
                    <c:v>0</c:v>
                  </c:pt>
                  <c:pt idx="6">
                    <c:v>1.2121830534627032E-2</c:v>
                  </c:pt>
                  <c:pt idx="7">
                    <c:v>3.0304576336538536E-3</c:v>
                  </c:pt>
                  <c:pt idx="8">
                    <c:v>1.8220120447343578E-2</c:v>
                  </c:pt>
                  <c:pt idx="9">
                    <c:v>1.8220120447343578E-2</c:v>
                  </c:pt>
                  <c:pt idx="10">
                    <c:v>0</c:v>
                  </c:pt>
                  <c:pt idx="11">
                    <c:v>3.030457633656732E-3</c:v>
                  </c:pt>
                  <c:pt idx="12">
                    <c:v>0</c:v>
                  </c:pt>
                  <c:pt idx="13">
                    <c:v>0</c:v>
                  </c:pt>
                  <c:pt idx="14">
                    <c:v>5.0507627227621681E-3</c:v>
                  </c:pt>
                  <c:pt idx="15">
                    <c:v>1.7172593257389165E-2</c:v>
                  </c:pt>
                  <c:pt idx="16">
                    <c:v>0</c:v>
                  </c:pt>
                  <c:pt idx="17">
                    <c:v>1.0101525445542323E-3</c:v>
                  </c:pt>
                  <c:pt idx="18">
                    <c:v>0</c:v>
                  </c:pt>
                  <c:pt idx="19">
                    <c:v>1.8182745801940497E-2</c:v>
                  </c:pt>
                  <c:pt idx="20">
                    <c:v>1.7172593257389183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1.919289834649502E-2</c:v>
                  </c:pt>
                  <c:pt idx="24">
                    <c:v>0</c:v>
                  </c:pt>
                  <c:pt idx="25">
                    <c:v>1.4142135623729334E-2</c:v>
                  </c:pt>
                  <c:pt idx="26">
                    <c:v>8.0812203564186863E-3</c:v>
                  </c:pt>
                  <c:pt idx="27">
                    <c:v>1.9192898346492095E-2</c:v>
                  </c:pt>
                  <c:pt idx="28">
                    <c:v>2.0203050891024047E-3</c:v>
                  </c:pt>
                  <c:pt idx="29">
                    <c:v>0</c:v>
                  </c:pt>
                  <c:pt idx="30">
                    <c:v>3.0304576336566292E-3</c:v>
                  </c:pt>
                  <c:pt idx="31">
                    <c:v>6.0609152673132584E-3</c:v>
                  </c:pt>
                  <c:pt idx="32">
                    <c:v>8.2832508653282302E-2</c:v>
                  </c:pt>
                  <c:pt idx="33">
                    <c:v>0</c:v>
                  </c:pt>
                  <c:pt idx="34">
                    <c:v>9.091372900969891E-3</c:v>
                  </c:pt>
                  <c:pt idx="35">
                    <c:v>1.2121830534626522E-2</c:v>
                  </c:pt>
                  <c:pt idx="36">
                    <c:v>9.091372900970212E-3</c:v>
                  </c:pt>
                  <c:pt idx="37">
                    <c:v>1.1111677990072705E-2</c:v>
                  </c:pt>
                  <c:pt idx="38">
                    <c:v>1.0101525445521599E-2</c:v>
                  </c:pt>
                  <c:pt idx="39">
                    <c:v>8.0812203564161016E-3</c:v>
                  </c:pt>
                  <c:pt idx="40">
                    <c:v>3.1314728881115583E-2</c:v>
                  </c:pt>
                  <c:pt idx="41">
                    <c:v>1.8182745801939817E-2</c:v>
                  </c:pt>
                  <c:pt idx="42">
                    <c:v>2.020305089105427E-3</c:v>
                  </c:pt>
                  <c:pt idx="43">
                    <c:v>2.02030508910542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I$287:$I$330</c:f>
              <c:strCache>
                <c:ptCount val="44"/>
                <c:pt idx="0">
                  <c:v>gCS1a</c:v>
                </c:pt>
                <c:pt idx="1">
                  <c:v>gS4b</c:v>
                </c:pt>
                <c:pt idx="2">
                  <c:v>wF10b</c:v>
                </c:pt>
                <c:pt idx="3">
                  <c:v>gCF2a</c:v>
                </c:pt>
                <c:pt idx="4">
                  <c:v>wF5a</c:v>
                </c:pt>
                <c:pt idx="5">
                  <c:v>gCS2a</c:v>
                </c:pt>
                <c:pt idx="6">
                  <c:v>wF5c</c:v>
                </c:pt>
                <c:pt idx="7">
                  <c:v>gCS5a</c:v>
                </c:pt>
                <c:pt idx="8">
                  <c:v>wF12b</c:v>
                </c:pt>
                <c:pt idx="9">
                  <c:v>wF12c</c:v>
                </c:pt>
                <c:pt idx="10">
                  <c:v>wF7c</c:v>
                </c:pt>
                <c:pt idx="11">
                  <c:v>wV1a</c:v>
                </c:pt>
                <c:pt idx="12">
                  <c:v>gS4c</c:v>
                </c:pt>
                <c:pt idx="13">
                  <c:v>gS3a</c:v>
                </c:pt>
                <c:pt idx="14">
                  <c:v>gCS6a</c:v>
                </c:pt>
                <c:pt idx="15">
                  <c:v>wF11d</c:v>
                </c:pt>
                <c:pt idx="16">
                  <c:v>wF7a</c:v>
                </c:pt>
                <c:pt idx="17">
                  <c:v>wF5b</c:v>
                </c:pt>
                <c:pt idx="18">
                  <c:v>wF10a</c:v>
                </c:pt>
                <c:pt idx="19">
                  <c:v>106</c:v>
                </c:pt>
                <c:pt idx="20">
                  <c:v>6707</c:v>
                </c:pt>
                <c:pt idx="21">
                  <c:v>6710</c:v>
                </c:pt>
                <c:pt idx="22">
                  <c:v>C21.4</c:v>
                </c:pt>
                <c:pt idx="23">
                  <c:v>C21.6</c:v>
                </c:pt>
                <c:pt idx="24">
                  <c:v>C21.1t1</c:v>
                </c:pt>
                <c:pt idx="25">
                  <c:v>C2.3</c:v>
                </c:pt>
                <c:pt idx="26">
                  <c:v>M1.</c:v>
                </c:pt>
                <c:pt idx="27">
                  <c:v>M4.</c:v>
                </c:pt>
                <c:pt idx="28">
                  <c:v>M5.</c:v>
                </c:pt>
                <c:pt idx="29">
                  <c:v>M6.</c:v>
                </c:pt>
                <c:pt idx="30">
                  <c:v>M12.</c:v>
                </c:pt>
                <c:pt idx="31">
                  <c:v>M11.</c:v>
                </c:pt>
                <c:pt idx="32">
                  <c:v>EB1G</c:v>
                </c:pt>
                <c:pt idx="33">
                  <c:v>EB1P</c:v>
                </c:pt>
                <c:pt idx="34">
                  <c:v>G3</c:v>
                </c:pt>
                <c:pt idx="35">
                  <c:v>G9</c:v>
                </c:pt>
                <c:pt idx="36">
                  <c:v>F6</c:v>
                </c:pt>
                <c:pt idx="37">
                  <c:v>F10</c:v>
                </c:pt>
                <c:pt idx="38">
                  <c:v>F32</c:v>
                </c:pt>
                <c:pt idx="39">
                  <c:v>F43</c:v>
                </c:pt>
                <c:pt idx="40">
                  <c:v>F14</c:v>
                </c:pt>
                <c:pt idx="41">
                  <c:v>F17</c:v>
                </c:pt>
                <c:pt idx="42">
                  <c:v>F22</c:v>
                </c:pt>
                <c:pt idx="43">
                  <c:v>F38</c:v>
                </c:pt>
              </c:strCache>
            </c:strRef>
          </c:cat>
          <c:val>
            <c:numRef>
              <c:f>Foglio1!$J$287:$J$330</c:f>
              <c:numCache>
                <c:formatCode>General</c:formatCode>
                <c:ptCount val="44"/>
                <c:pt idx="0">
                  <c:v>5.2142857142856353E-2</c:v>
                </c:pt>
                <c:pt idx="1">
                  <c:v>6.0714285714287358E-2</c:v>
                </c:pt>
                <c:pt idx="2">
                  <c:v>7.0714285714286354E-2</c:v>
                </c:pt>
                <c:pt idx="3">
                  <c:v>4.5000000000001719E-2</c:v>
                </c:pt>
                <c:pt idx="4">
                  <c:v>4.5000000000001719E-2</c:v>
                </c:pt>
                <c:pt idx="5">
                  <c:v>3.0000000000001144E-2</c:v>
                </c:pt>
                <c:pt idx="6">
                  <c:v>2.4285714285712499E-2</c:v>
                </c:pt>
                <c:pt idx="7">
                  <c:v>1.3571428571428394E-2</c:v>
                </c:pt>
                <c:pt idx="8">
                  <c:v>2.6428571428571787E-2</c:v>
                </c:pt>
                <c:pt idx="9">
                  <c:v>2.6428571428571787E-2</c:v>
                </c:pt>
                <c:pt idx="10">
                  <c:v>4.9000000000000002E-2</c:v>
                </c:pt>
                <c:pt idx="11">
                  <c:v>3.3571428571428502E-2</c:v>
                </c:pt>
                <c:pt idx="12">
                  <c:v>4.7142857142854856E-2</c:v>
                </c:pt>
                <c:pt idx="13">
                  <c:v>4.5714285714284715E-2</c:v>
                </c:pt>
                <c:pt idx="14">
                  <c:v>2.0714285714287215E-2</c:v>
                </c:pt>
                <c:pt idx="15">
                  <c:v>5.3571428571428575E-2</c:v>
                </c:pt>
                <c:pt idx="16">
                  <c:v>4.9999999999999996E-2</c:v>
                </c:pt>
                <c:pt idx="17">
                  <c:v>2.2142857142855285E-2</c:v>
                </c:pt>
                <c:pt idx="18">
                  <c:v>2.8571428571428574E-2</c:v>
                </c:pt>
                <c:pt idx="19">
                  <c:v>0.12214285714285571</c:v>
                </c:pt>
                <c:pt idx="20">
                  <c:v>4.1428571428574354E-2</c:v>
                </c:pt>
                <c:pt idx="21">
                  <c:v>0.15714285714285572</c:v>
                </c:pt>
                <c:pt idx="22">
                  <c:v>0.150714285714285</c:v>
                </c:pt>
                <c:pt idx="23">
                  <c:v>0.1542857142857143</c:v>
                </c:pt>
                <c:pt idx="24">
                  <c:v>0.14428571428571685</c:v>
                </c:pt>
                <c:pt idx="25">
                  <c:v>0.15428571428571358</c:v>
                </c:pt>
                <c:pt idx="26">
                  <c:v>0.15214285714285708</c:v>
                </c:pt>
                <c:pt idx="27">
                  <c:v>0.15142857142857144</c:v>
                </c:pt>
                <c:pt idx="28">
                  <c:v>0.15</c:v>
                </c:pt>
                <c:pt idx="29">
                  <c:v>0.1507142857142843</c:v>
                </c:pt>
                <c:pt idx="30">
                  <c:v>0.15142857142857144</c:v>
                </c:pt>
                <c:pt idx="31">
                  <c:v>9.5714285714286432E-2</c:v>
                </c:pt>
                <c:pt idx="32">
                  <c:v>0.12857142857142859</c:v>
                </c:pt>
                <c:pt idx="33">
                  <c:v>3.2142857142857147E-2</c:v>
                </c:pt>
                <c:pt idx="34">
                  <c:v>3.8571428571428576E-2</c:v>
                </c:pt>
                <c:pt idx="35">
                  <c:v>9.9999999999999992E-2</c:v>
                </c:pt>
                <c:pt idx="36">
                  <c:v>8.928571428571222E-2</c:v>
                </c:pt>
                <c:pt idx="37">
                  <c:v>0.13642857142857112</c:v>
                </c:pt>
                <c:pt idx="38">
                  <c:v>2.5714285714284642E-2</c:v>
                </c:pt>
                <c:pt idx="39">
                  <c:v>3.8571428571426002E-2</c:v>
                </c:pt>
                <c:pt idx="40">
                  <c:v>0.16785714285714215</c:v>
                </c:pt>
                <c:pt idx="41">
                  <c:v>0.18285714285714286</c:v>
                </c:pt>
                <c:pt idx="42">
                  <c:v>0.185714285714285</c:v>
                </c:pt>
                <c:pt idx="43">
                  <c:v>0.17428571428571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4-13C3-4712-B86C-D8C2E717B2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3209952"/>
        <c:axId val="663210312"/>
      </c:barChart>
      <c:catAx>
        <c:axId val="663209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210312"/>
        <c:crosses val="autoZero"/>
        <c:auto val="1"/>
        <c:lblAlgn val="ctr"/>
        <c:lblOffset val="100"/>
        <c:noMultiLvlLbl val="0"/>
      </c:catAx>
      <c:valAx>
        <c:axId val="6632103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209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dirty="0" err="1"/>
              <a:t>Ethyl</a:t>
            </a:r>
            <a:r>
              <a:rPr lang="it-IT" dirty="0"/>
              <a:t> </a:t>
            </a:r>
            <a:r>
              <a:rPr lang="it-IT" dirty="0" err="1"/>
              <a:t>guaiacol</a:t>
            </a:r>
            <a:endParaRPr lang="it-IT" dirty="0"/>
          </a:p>
          <a:p>
            <a:pPr>
              <a:defRPr/>
            </a:pPr>
            <a:r>
              <a:rPr lang="it-IT" dirty="0"/>
              <a:t>mg/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DCA-4BFE-B66E-BAC3B3613432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DCA-4BFE-B66E-BAC3B3613432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DCA-4BFE-B66E-BAC3B3613432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DCA-4BFE-B66E-BAC3B3613432}"/>
              </c:ext>
            </c:extLst>
          </c:dPt>
          <c:dPt>
            <c:idx val="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DCA-4BFE-B66E-BAC3B3613432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DCA-4BFE-B66E-BAC3B3613432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3DCA-4BFE-B66E-BAC3B3613432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3DCA-4BFE-B66E-BAC3B3613432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3DCA-4BFE-B66E-BAC3B3613432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3DCA-4BFE-B66E-BAC3B3613432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3DCA-4BFE-B66E-BAC3B3613432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3DCA-4BFE-B66E-BAC3B3613432}"/>
              </c:ext>
            </c:extLst>
          </c:dPt>
          <c:dPt>
            <c:idx val="1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3DCA-4BFE-B66E-BAC3B3613432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3DCA-4BFE-B66E-BAC3B3613432}"/>
              </c:ext>
            </c:extLst>
          </c:dPt>
          <c:dPt>
            <c:idx val="1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3DCA-4BFE-B66E-BAC3B3613432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3DCA-4BFE-B66E-BAC3B3613432}"/>
              </c:ext>
            </c:extLst>
          </c:dPt>
          <c:dPt>
            <c:idx val="1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3DCA-4BFE-B66E-BAC3B3613432}"/>
              </c:ext>
            </c:extLst>
          </c:dPt>
          <c:dPt>
            <c:idx val="1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3DCA-4BFE-B66E-BAC3B3613432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3DCA-4BFE-B66E-BAC3B3613432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3DCA-4BFE-B66E-BAC3B3613432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3DCA-4BFE-B66E-BAC3B3613432}"/>
              </c:ext>
            </c:extLst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3DCA-4BFE-B66E-BAC3B3613432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3DCA-4BFE-B66E-BAC3B3613432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3DCA-4BFE-B66E-BAC3B3613432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3DCA-4BFE-B66E-BAC3B3613432}"/>
              </c:ext>
            </c:extLst>
          </c:dPt>
          <c:dPt>
            <c:idx val="25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3DCA-4BFE-B66E-BAC3B3613432}"/>
              </c:ext>
            </c:extLst>
          </c:dPt>
          <c:dPt>
            <c:idx val="26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3DCA-4BFE-B66E-BAC3B3613432}"/>
              </c:ext>
            </c:extLst>
          </c:dPt>
          <c:dPt>
            <c:idx val="27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3DCA-4BFE-B66E-BAC3B3613432}"/>
              </c:ext>
            </c:extLst>
          </c:dPt>
          <c:dPt>
            <c:idx val="28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3DCA-4BFE-B66E-BAC3B3613432}"/>
              </c:ext>
            </c:extLst>
          </c:dPt>
          <c:dPt>
            <c:idx val="29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3DCA-4BFE-B66E-BAC3B3613432}"/>
              </c:ext>
            </c:extLst>
          </c:dPt>
          <c:dPt>
            <c:idx val="3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3DCA-4BFE-B66E-BAC3B3613432}"/>
              </c:ext>
            </c:extLst>
          </c:dPt>
          <c:dPt>
            <c:idx val="3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F-3DCA-4BFE-B66E-BAC3B3613432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1-3DCA-4BFE-B66E-BAC3B3613432}"/>
              </c:ext>
            </c:extLst>
          </c:dPt>
          <c:dPt>
            <c:idx val="35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3-3DCA-4BFE-B66E-BAC3B3613432}"/>
              </c:ext>
            </c:extLst>
          </c:dPt>
          <c:dPt>
            <c:idx val="36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5-3DCA-4BFE-B66E-BAC3B3613432}"/>
              </c:ext>
            </c:extLst>
          </c:dPt>
          <c:dPt>
            <c:idx val="37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7-3DCA-4BFE-B66E-BAC3B3613432}"/>
              </c:ext>
            </c:extLst>
          </c:dPt>
          <c:dPt>
            <c:idx val="38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9-3DCA-4BFE-B66E-BAC3B3613432}"/>
              </c:ext>
            </c:extLst>
          </c:dPt>
          <c:dPt>
            <c:idx val="39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B-3DCA-4BFE-B66E-BAC3B3613432}"/>
              </c:ext>
            </c:extLst>
          </c:dPt>
          <c:dPt>
            <c:idx val="40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D-3DCA-4BFE-B66E-BAC3B3613432}"/>
              </c:ext>
            </c:extLst>
          </c:dPt>
          <c:dPt>
            <c:idx val="41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F-3DCA-4BFE-B66E-BAC3B3613432}"/>
              </c:ext>
            </c:extLst>
          </c:dPt>
          <c:dPt>
            <c:idx val="4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1-3DCA-4BFE-B66E-BAC3B3613432}"/>
              </c:ext>
            </c:extLst>
          </c:dPt>
          <c:errBars>
            <c:errBarType val="both"/>
            <c:errValType val="cust"/>
            <c:noEndCap val="0"/>
            <c:plus>
              <c:numRef>
                <c:f>Foglio1!$K$144:$K$187</c:f>
                <c:numCache>
                  <c:formatCode>General</c:formatCode>
                  <c:ptCount val="44"/>
                  <c:pt idx="0">
                    <c:v>6.6468037431535301E-2</c:v>
                  </c:pt>
                  <c:pt idx="1">
                    <c:v>4.2426406871192479E-2</c:v>
                  </c:pt>
                  <c:pt idx="2">
                    <c:v>6.363961030678926E-2</c:v>
                  </c:pt>
                  <c:pt idx="3">
                    <c:v>7.2124891681027925E-2</c:v>
                  </c:pt>
                  <c:pt idx="4">
                    <c:v>1.3435028842544395E-2</c:v>
                  </c:pt>
                  <c:pt idx="5">
                    <c:v>0</c:v>
                  </c:pt>
                  <c:pt idx="6">
                    <c:v>8.9095454429504839E-2</c:v>
                  </c:pt>
                  <c:pt idx="7">
                    <c:v>2.2627416997969541E-2</c:v>
                  </c:pt>
                  <c:pt idx="8">
                    <c:v>5.2239033936958182E-2</c:v>
                  </c:pt>
                  <c:pt idx="9">
                    <c:v>5.2239033936958182E-2</c:v>
                  </c:pt>
                  <c:pt idx="10">
                    <c:v>0</c:v>
                  </c:pt>
                  <c:pt idx="11">
                    <c:v>7.0710678118654814E-3</c:v>
                  </c:pt>
                  <c:pt idx="12">
                    <c:v>9.8994949366116736E-3</c:v>
                  </c:pt>
                  <c:pt idx="13">
                    <c:v>0</c:v>
                  </c:pt>
                  <c:pt idx="14">
                    <c:v>4.2426406871192892E-3</c:v>
                  </c:pt>
                  <c:pt idx="15">
                    <c:v>4.9497474683058368E-3</c:v>
                  </c:pt>
                  <c:pt idx="16">
                    <c:v>0</c:v>
                  </c:pt>
                  <c:pt idx="17">
                    <c:v>1.2020815280171319E-2</c:v>
                  </c:pt>
                  <c:pt idx="18">
                    <c:v>0</c:v>
                  </c:pt>
                  <c:pt idx="19">
                    <c:v>4.0305086527633219E-2</c:v>
                  </c:pt>
                  <c:pt idx="20">
                    <c:v>7.0003571337468276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7.7781745930520299E-3</c:v>
                  </c:pt>
                  <c:pt idx="24">
                    <c:v>0</c:v>
                  </c:pt>
                  <c:pt idx="25">
                    <c:v>5.3033008588991022E-2</c:v>
                  </c:pt>
                  <c:pt idx="26">
                    <c:v>9.8994949366116736E-3</c:v>
                  </c:pt>
                  <c:pt idx="27">
                    <c:v>3.6769552621700362E-2</c:v>
                  </c:pt>
                  <c:pt idx="28">
                    <c:v>3.2526911934581133E-2</c:v>
                  </c:pt>
                  <c:pt idx="29">
                    <c:v>0</c:v>
                  </c:pt>
                  <c:pt idx="30">
                    <c:v>6.3639610306789138E-3</c:v>
                  </c:pt>
                  <c:pt idx="31">
                    <c:v>5.798275605729681E-2</c:v>
                  </c:pt>
                  <c:pt idx="32">
                    <c:v>3.8890872965260115E-2</c:v>
                  </c:pt>
                  <c:pt idx="33">
                    <c:v>0</c:v>
                  </c:pt>
                  <c:pt idx="34">
                    <c:v>7.2831998462214331E-2</c:v>
                  </c:pt>
                  <c:pt idx="35">
                    <c:v>2.4041630560342638E-2</c:v>
                  </c:pt>
                  <c:pt idx="36">
                    <c:v>0.12162236636408623</c:v>
                  </c:pt>
                  <c:pt idx="37">
                    <c:v>5.3740115370177366E-2</c:v>
                  </c:pt>
                  <c:pt idx="38">
                    <c:v>8.5559920523572211E-2</c:v>
                  </c:pt>
                  <c:pt idx="39">
                    <c:v>1.3435028842544414E-2</c:v>
                  </c:pt>
                  <c:pt idx="40">
                    <c:v>7.5660425586960539E-2</c:v>
                  </c:pt>
                  <c:pt idx="41">
                    <c:v>5.3033008588991085E-2</c:v>
                  </c:pt>
                  <c:pt idx="42">
                    <c:v>8.131727983645301E-2</c:v>
                  </c:pt>
                  <c:pt idx="43">
                    <c:v>4.3133513652379413E-2</c:v>
                  </c:pt>
                </c:numCache>
              </c:numRef>
            </c:plus>
            <c:minus>
              <c:numRef>
                <c:f>Foglio1!$K$144:$K$187</c:f>
                <c:numCache>
                  <c:formatCode>General</c:formatCode>
                  <c:ptCount val="44"/>
                  <c:pt idx="0">
                    <c:v>6.6468037431535301E-2</c:v>
                  </c:pt>
                  <c:pt idx="1">
                    <c:v>4.2426406871192479E-2</c:v>
                  </c:pt>
                  <c:pt idx="2">
                    <c:v>6.363961030678926E-2</c:v>
                  </c:pt>
                  <c:pt idx="3">
                    <c:v>7.2124891681027925E-2</c:v>
                  </c:pt>
                  <c:pt idx="4">
                    <c:v>1.3435028842544395E-2</c:v>
                  </c:pt>
                  <c:pt idx="5">
                    <c:v>0</c:v>
                  </c:pt>
                  <c:pt idx="6">
                    <c:v>8.9095454429504839E-2</c:v>
                  </c:pt>
                  <c:pt idx="7">
                    <c:v>2.2627416997969541E-2</c:v>
                  </c:pt>
                  <c:pt idx="8">
                    <c:v>5.2239033936958182E-2</c:v>
                  </c:pt>
                  <c:pt idx="9">
                    <c:v>5.2239033936958182E-2</c:v>
                  </c:pt>
                  <c:pt idx="10">
                    <c:v>0</c:v>
                  </c:pt>
                  <c:pt idx="11">
                    <c:v>7.0710678118654814E-3</c:v>
                  </c:pt>
                  <c:pt idx="12">
                    <c:v>9.8994949366116736E-3</c:v>
                  </c:pt>
                  <c:pt idx="13">
                    <c:v>0</c:v>
                  </c:pt>
                  <c:pt idx="14">
                    <c:v>4.2426406871192892E-3</c:v>
                  </c:pt>
                  <c:pt idx="15">
                    <c:v>4.9497474683058368E-3</c:v>
                  </c:pt>
                  <c:pt idx="16">
                    <c:v>0</c:v>
                  </c:pt>
                  <c:pt idx="17">
                    <c:v>1.2020815280171319E-2</c:v>
                  </c:pt>
                  <c:pt idx="18">
                    <c:v>0</c:v>
                  </c:pt>
                  <c:pt idx="19">
                    <c:v>4.0305086527633219E-2</c:v>
                  </c:pt>
                  <c:pt idx="20">
                    <c:v>7.0003571337468276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7.7781745930520299E-3</c:v>
                  </c:pt>
                  <c:pt idx="24">
                    <c:v>0</c:v>
                  </c:pt>
                  <c:pt idx="25">
                    <c:v>5.3033008588991022E-2</c:v>
                  </c:pt>
                  <c:pt idx="26">
                    <c:v>9.8994949366116736E-3</c:v>
                  </c:pt>
                  <c:pt idx="27">
                    <c:v>3.6769552621700362E-2</c:v>
                  </c:pt>
                  <c:pt idx="28">
                    <c:v>3.2526911934581133E-2</c:v>
                  </c:pt>
                  <c:pt idx="29">
                    <c:v>0</c:v>
                  </c:pt>
                  <c:pt idx="30">
                    <c:v>6.3639610306789138E-3</c:v>
                  </c:pt>
                  <c:pt idx="31">
                    <c:v>5.798275605729681E-2</c:v>
                  </c:pt>
                  <c:pt idx="32">
                    <c:v>3.8890872965260115E-2</c:v>
                  </c:pt>
                  <c:pt idx="33">
                    <c:v>0</c:v>
                  </c:pt>
                  <c:pt idx="34">
                    <c:v>7.2831998462214331E-2</c:v>
                  </c:pt>
                  <c:pt idx="35">
                    <c:v>2.4041630560342638E-2</c:v>
                  </c:pt>
                  <c:pt idx="36">
                    <c:v>0.12162236636408623</c:v>
                  </c:pt>
                  <c:pt idx="37">
                    <c:v>5.3740115370177366E-2</c:v>
                  </c:pt>
                  <c:pt idx="38">
                    <c:v>8.5559920523572211E-2</c:v>
                  </c:pt>
                  <c:pt idx="39">
                    <c:v>1.3435028842544414E-2</c:v>
                  </c:pt>
                  <c:pt idx="40">
                    <c:v>7.5660425586960539E-2</c:v>
                  </c:pt>
                  <c:pt idx="41">
                    <c:v>5.3033008588991085E-2</c:v>
                  </c:pt>
                  <c:pt idx="42">
                    <c:v>8.131727983645301E-2</c:v>
                  </c:pt>
                  <c:pt idx="43">
                    <c:v>4.31335136523794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K$193:$K$235</c:f>
              <c:strCache>
                <c:ptCount val="43"/>
                <c:pt idx="0">
                  <c:v>gS4b</c:v>
                </c:pt>
                <c:pt idx="1">
                  <c:v>wF10b</c:v>
                </c:pt>
                <c:pt idx="2">
                  <c:v>gCF2a</c:v>
                </c:pt>
                <c:pt idx="3">
                  <c:v>wF5a</c:v>
                </c:pt>
                <c:pt idx="4">
                  <c:v>gCS2a</c:v>
                </c:pt>
                <c:pt idx="5">
                  <c:v>wF5c</c:v>
                </c:pt>
                <c:pt idx="6">
                  <c:v>gCS5a</c:v>
                </c:pt>
                <c:pt idx="7">
                  <c:v>wF12b</c:v>
                </c:pt>
                <c:pt idx="8">
                  <c:v>wF12c</c:v>
                </c:pt>
                <c:pt idx="9">
                  <c:v>wF7c</c:v>
                </c:pt>
                <c:pt idx="10">
                  <c:v>wV1a</c:v>
                </c:pt>
                <c:pt idx="11">
                  <c:v>gS4c</c:v>
                </c:pt>
                <c:pt idx="12">
                  <c:v>gS3a</c:v>
                </c:pt>
                <c:pt idx="13">
                  <c:v>gCS6a</c:v>
                </c:pt>
                <c:pt idx="14">
                  <c:v>wF11d</c:v>
                </c:pt>
                <c:pt idx="15">
                  <c:v>wF7a</c:v>
                </c:pt>
                <c:pt idx="16">
                  <c:v>wF5b</c:v>
                </c:pt>
                <c:pt idx="17">
                  <c:v>wF10a</c:v>
                </c:pt>
                <c:pt idx="18">
                  <c:v>106</c:v>
                </c:pt>
                <c:pt idx="19">
                  <c:v>6707</c:v>
                </c:pt>
                <c:pt idx="20">
                  <c:v>6710</c:v>
                </c:pt>
                <c:pt idx="21">
                  <c:v>C21.4</c:v>
                </c:pt>
                <c:pt idx="22">
                  <c:v>C21.6</c:v>
                </c:pt>
                <c:pt idx="23">
                  <c:v>C21.1t1</c:v>
                </c:pt>
                <c:pt idx="24">
                  <c:v>C2.3</c:v>
                </c:pt>
                <c:pt idx="25">
                  <c:v>M1.</c:v>
                </c:pt>
                <c:pt idx="26">
                  <c:v>M4.</c:v>
                </c:pt>
                <c:pt idx="27">
                  <c:v>M5.</c:v>
                </c:pt>
                <c:pt idx="28">
                  <c:v>M6.</c:v>
                </c:pt>
                <c:pt idx="29">
                  <c:v>M12.</c:v>
                </c:pt>
                <c:pt idx="30">
                  <c:v>M11.</c:v>
                </c:pt>
                <c:pt idx="31">
                  <c:v>EB1G</c:v>
                </c:pt>
                <c:pt idx="32">
                  <c:v>EB1P</c:v>
                </c:pt>
                <c:pt idx="33">
                  <c:v>G3</c:v>
                </c:pt>
                <c:pt idx="34">
                  <c:v>G9</c:v>
                </c:pt>
                <c:pt idx="35">
                  <c:v>F6</c:v>
                </c:pt>
                <c:pt idx="36">
                  <c:v>F10</c:v>
                </c:pt>
                <c:pt idx="37">
                  <c:v>F32</c:v>
                </c:pt>
                <c:pt idx="38">
                  <c:v>F43</c:v>
                </c:pt>
                <c:pt idx="39">
                  <c:v>F14</c:v>
                </c:pt>
                <c:pt idx="40">
                  <c:v>F17</c:v>
                </c:pt>
                <c:pt idx="41">
                  <c:v>F22</c:v>
                </c:pt>
                <c:pt idx="42">
                  <c:v>F38</c:v>
                </c:pt>
              </c:strCache>
            </c:strRef>
          </c:cat>
          <c:val>
            <c:numRef>
              <c:f>Foglio1!$L$193:$L$235</c:f>
              <c:numCache>
                <c:formatCode>General</c:formatCode>
                <c:ptCount val="43"/>
                <c:pt idx="0">
                  <c:v>0.29700000000000004</c:v>
                </c:pt>
                <c:pt idx="1">
                  <c:v>0.16200000000000001</c:v>
                </c:pt>
                <c:pt idx="2">
                  <c:v>0.17799999999999999</c:v>
                </c:pt>
                <c:pt idx="3">
                  <c:v>0.17799999999999999</c:v>
                </c:pt>
                <c:pt idx="4">
                  <c:v>0.24399999999999999</c:v>
                </c:pt>
                <c:pt idx="5">
                  <c:v>0.27700000000000002</c:v>
                </c:pt>
                <c:pt idx="6">
                  <c:v>0.254</c:v>
                </c:pt>
                <c:pt idx="7">
                  <c:v>0.14599999999999999</c:v>
                </c:pt>
                <c:pt idx="8">
                  <c:v>0.14599999999999999</c:v>
                </c:pt>
                <c:pt idx="9">
                  <c:v>0.17499999999999999</c:v>
                </c:pt>
                <c:pt idx="10">
                  <c:v>0.189</c:v>
                </c:pt>
                <c:pt idx="11">
                  <c:v>0.157</c:v>
                </c:pt>
                <c:pt idx="12">
                  <c:v>0.41499999999999998</c:v>
                </c:pt>
                <c:pt idx="13">
                  <c:v>6.4000000000000001E-2</c:v>
                </c:pt>
                <c:pt idx="14">
                  <c:v>0.2175</c:v>
                </c:pt>
                <c:pt idx="15">
                  <c:v>0.17699999999999999</c:v>
                </c:pt>
                <c:pt idx="16">
                  <c:v>0.19450000000000001</c:v>
                </c:pt>
                <c:pt idx="17">
                  <c:v>0.17599999999999999</c:v>
                </c:pt>
                <c:pt idx="18">
                  <c:v>0.1525</c:v>
                </c:pt>
                <c:pt idx="19">
                  <c:v>0.19750000000000001</c:v>
                </c:pt>
                <c:pt idx="20">
                  <c:v>0.216</c:v>
                </c:pt>
                <c:pt idx="21">
                  <c:v>0.1115</c:v>
                </c:pt>
                <c:pt idx="22">
                  <c:v>0.06</c:v>
                </c:pt>
                <c:pt idx="23">
                  <c:v>0.1845</c:v>
                </c:pt>
                <c:pt idx="24">
                  <c:v>0.153</c:v>
                </c:pt>
                <c:pt idx="25">
                  <c:v>0.224</c:v>
                </c:pt>
                <c:pt idx="26">
                  <c:v>0.126</c:v>
                </c:pt>
                <c:pt idx="27">
                  <c:v>0.17199999999999999</c:v>
                </c:pt>
                <c:pt idx="28">
                  <c:v>0.20750000000000002</c:v>
                </c:pt>
                <c:pt idx="29">
                  <c:v>0.13700000000000001</c:v>
                </c:pt>
                <c:pt idx="30">
                  <c:v>0.14749999999999999</c:v>
                </c:pt>
                <c:pt idx="31">
                  <c:v>0.16300000000000001</c:v>
                </c:pt>
                <c:pt idx="32">
                  <c:v>0.42149999999999999</c:v>
                </c:pt>
                <c:pt idx="33">
                  <c:v>0.307</c:v>
                </c:pt>
                <c:pt idx="34">
                  <c:v>0.16</c:v>
                </c:pt>
                <c:pt idx="35">
                  <c:v>0.217</c:v>
                </c:pt>
                <c:pt idx="36">
                  <c:v>0.26700000000000002</c:v>
                </c:pt>
                <c:pt idx="37">
                  <c:v>0.13850000000000001</c:v>
                </c:pt>
                <c:pt idx="38">
                  <c:v>0.19350000000000001</c:v>
                </c:pt>
                <c:pt idx="39">
                  <c:v>0.14750000000000002</c:v>
                </c:pt>
                <c:pt idx="40">
                  <c:v>0.16749999999999998</c:v>
                </c:pt>
                <c:pt idx="41">
                  <c:v>0.22449999999999998</c:v>
                </c:pt>
                <c:pt idx="42">
                  <c:v>9.45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3DCA-4BFE-B66E-BAC3B36134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3037680"/>
        <c:axId val="663035160"/>
      </c:barChart>
      <c:catAx>
        <c:axId val="663037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035160"/>
        <c:crosses val="autoZero"/>
        <c:auto val="1"/>
        <c:lblAlgn val="ctr"/>
        <c:lblOffset val="100"/>
        <c:noMultiLvlLbl val="0"/>
      </c:catAx>
      <c:valAx>
        <c:axId val="6630351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3037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/>
              <a:t>ethylphenols</a:t>
            </a:r>
          </a:p>
          <a:p>
            <a:pPr>
              <a:defRPr/>
            </a:pPr>
            <a:r>
              <a:rPr lang="it-IT"/>
              <a:t>mg/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72B-4D39-8FC7-A4C160B99E18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72B-4D39-8FC7-A4C160B99E18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72B-4D39-8FC7-A4C160B99E18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72B-4D39-8FC7-A4C160B99E18}"/>
              </c:ext>
            </c:extLst>
          </c:dPt>
          <c:dPt>
            <c:idx val="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72B-4D39-8FC7-A4C160B99E18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72B-4D39-8FC7-A4C160B99E18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572B-4D39-8FC7-A4C160B99E18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572B-4D39-8FC7-A4C160B99E18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572B-4D39-8FC7-A4C160B99E18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572B-4D39-8FC7-A4C160B99E18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572B-4D39-8FC7-A4C160B99E18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572B-4D39-8FC7-A4C160B99E18}"/>
              </c:ext>
            </c:extLst>
          </c:dPt>
          <c:dPt>
            <c:idx val="1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572B-4D39-8FC7-A4C160B99E18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572B-4D39-8FC7-A4C160B99E18}"/>
              </c:ext>
            </c:extLst>
          </c:dPt>
          <c:dPt>
            <c:idx val="1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572B-4D39-8FC7-A4C160B99E18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572B-4D39-8FC7-A4C160B99E18}"/>
              </c:ext>
            </c:extLst>
          </c:dPt>
          <c:dPt>
            <c:idx val="1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572B-4D39-8FC7-A4C160B99E18}"/>
              </c:ext>
            </c:extLst>
          </c:dPt>
          <c:dPt>
            <c:idx val="1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572B-4D39-8FC7-A4C160B99E18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572B-4D39-8FC7-A4C160B99E18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572B-4D39-8FC7-A4C160B99E18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572B-4D39-8FC7-A4C160B99E18}"/>
              </c:ext>
            </c:extLst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572B-4D39-8FC7-A4C160B99E18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572B-4D39-8FC7-A4C160B99E18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572B-4D39-8FC7-A4C160B99E18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572B-4D39-8FC7-A4C160B99E18}"/>
              </c:ext>
            </c:extLst>
          </c:dPt>
          <c:dPt>
            <c:idx val="25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572B-4D39-8FC7-A4C160B99E18}"/>
              </c:ext>
            </c:extLst>
          </c:dPt>
          <c:dPt>
            <c:idx val="26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572B-4D39-8FC7-A4C160B99E18}"/>
              </c:ext>
            </c:extLst>
          </c:dPt>
          <c:dPt>
            <c:idx val="27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572B-4D39-8FC7-A4C160B99E18}"/>
              </c:ext>
            </c:extLst>
          </c:dPt>
          <c:dPt>
            <c:idx val="28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572B-4D39-8FC7-A4C160B99E18}"/>
              </c:ext>
            </c:extLst>
          </c:dPt>
          <c:dPt>
            <c:idx val="29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572B-4D39-8FC7-A4C160B99E18}"/>
              </c:ext>
            </c:extLst>
          </c:dPt>
          <c:dPt>
            <c:idx val="3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572B-4D39-8FC7-A4C160B99E18}"/>
              </c:ext>
            </c:extLst>
          </c:dPt>
          <c:dPt>
            <c:idx val="3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F-572B-4D39-8FC7-A4C160B99E18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1-572B-4D39-8FC7-A4C160B99E18}"/>
              </c:ext>
            </c:extLst>
          </c:dPt>
          <c:dPt>
            <c:idx val="35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3-572B-4D39-8FC7-A4C160B99E18}"/>
              </c:ext>
            </c:extLst>
          </c:dPt>
          <c:dPt>
            <c:idx val="36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5-572B-4D39-8FC7-A4C160B99E18}"/>
              </c:ext>
            </c:extLst>
          </c:dPt>
          <c:dPt>
            <c:idx val="37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7-572B-4D39-8FC7-A4C160B99E18}"/>
              </c:ext>
            </c:extLst>
          </c:dPt>
          <c:dPt>
            <c:idx val="38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9-572B-4D39-8FC7-A4C160B99E18}"/>
              </c:ext>
            </c:extLst>
          </c:dPt>
          <c:dPt>
            <c:idx val="39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B-572B-4D39-8FC7-A4C160B99E18}"/>
              </c:ext>
            </c:extLst>
          </c:dPt>
          <c:dPt>
            <c:idx val="40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D-572B-4D39-8FC7-A4C160B99E18}"/>
              </c:ext>
            </c:extLst>
          </c:dPt>
          <c:dPt>
            <c:idx val="41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F-572B-4D39-8FC7-A4C160B99E18}"/>
              </c:ext>
            </c:extLst>
          </c:dPt>
          <c:dPt>
            <c:idx val="4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1-572B-4D39-8FC7-A4C160B99E18}"/>
              </c:ext>
            </c:extLst>
          </c:dPt>
          <c:errBars>
            <c:errBarType val="both"/>
            <c:errValType val="cust"/>
            <c:noEndCap val="0"/>
            <c:plus>
              <c:numRef>
                <c:f>Foglio1!$J$144:$J$187</c:f>
                <c:numCache>
                  <c:formatCode>General</c:formatCode>
                  <c:ptCount val="44"/>
                  <c:pt idx="0">
                    <c:v>7.4246212024587477E-2</c:v>
                  </c:pt>
                  <c:pt idx="1">
                    <c:v>5.0204581464244995E-2</c:v>
                  </c:pt>
                  <c:pt idx="2">
                    <c:v>0.3075914498161485</c:v>
                  </c:pt>
                  <c:pt idx="3">
                    <c:v>0.17253405460951765</c:v>
                  </c:pt>
                  <c:pt idx="4">
                    <c:v>6.0104076400856514E-2</c:v>
                  </c:pt>
                  <c:pt idx="5">
                    <c:v>0.21213203435596409</c:v>
                  </c:pt>
                  <c:pt idx="6">
                    <c:v>0.24819448019647808</c:v>
                  </c:pt>
                  <c:pt idx="7">
                    <c:v>0.28779245994292457</c:v>
                  </c:pt>
                  <c:pt idx="8">
                    <c:v>0.10223624601871889</c:v>
                  </c:pt>
                  <c:pt idx="9">
                    <c:v>0.10223624601871889</c:v>
                  </c:pt>
                  <c:pt idx="10">
                    <c:v>0</c:v>
                  </c:pt>
                  <c:pt idx="11">
                    <c:v>3.6062445840513956E-2</c:v>
                  </c:pt>
                  <c:pt idx="12">
                    <c:v>0.11879393923933958</c:v>
                  </c:pt>
                  <c:pt idx="13">
                    <c:v>0</c:v>
                  </c:pt>
                  <c:pt idx="14">
                    <c:v>0.24041630560342656</c:v>
                  </c:pt>
                  <c:pt idx="15">
                    <c:v>7.0710678118654816E-4</c:v>
                  </c:pt>
                  <c:pt idx="16">
                    <c:v>0</c:v>
                  </c:pt>
                  <c:pt idx="17">
                    <c:v>2.8284271247461849E-2</c:v>
                  </c:pt>
                  <c:pt idx="18">
                    <c:v>0</c:v>
                  </c:pt>
                  <c:pt idx="19">
                    <c:v>0.17606958851545093</c:v>
                  </c:pt>
                  <c:pt idx="20">
                    <c:v>5.2325901807804484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17606958851545093</c:v>
                  </c:pt>
                  <c:pt idx="24">
                    <c:v>0</c:v>
                  </c:pt>
                  <c:pt idx="25">
                    <c:v>9.1923881554251269E-3</c:v>
                  </c:pt>
                  <c:pt idx="26">
                    <c:v>4.030508652763317E-2</c:v>
                  </c:pt>
                  <c:pt idx="27">
                    <c:v>2.8284271247461926E-2</c:v>
                  </c:pt>
                  <c:pt idx="28">
                    <c:v>2.2627416997969461E-2</c:v>
                  </c:pt>
                  <c:pt idx="29">
                    <c:v>0</c:v>
                  </c:pt>
                  <c:pt idx="30">
                    <c:v>0.12020815280171339</c:v>
                  </c:pt>
                  <c:pt idx="31">
                    <c:v>0.19940411229460603</c:v>
                  </c:pt>
                  <c:pt idx="32">
                    <c:v>0.17253405460951732</c:v>
                  </c:pt>
                  <c:pt idx="33">
                    <c:v>0</c:v>
                  </c:pt>
                  <c:pt idx="34">
                    <c:v>0.22698127676088156</c:v>
                  </c:pt>
                  <c:pt idx="35">
                    <c:v>0.1209152595828995</c:v>
                  </c:pt>
                  <c:pt idx="36">
                    <c:v>0.22132442251138984</c:v>
                  </c:pt>
                  <c:pt idx="37">
                    <c:v>6.5760930650348895E-2</c:v>
                  </c:pt>
                  <c:pt idx="38">
                    <c:v>3.0405591591021571E-2</c:v>
                  </c:pt>
                  <c:pt idx="39">
                    <c:v>1.2020815280171319E-2</c:v>
                  </c:pt>
                  <c:pt idx="40">
                    <c:v>0.21778888860545645</c:v>
                  </c:pt>
                  <c:pt idx="41">
                    <c:v>0.16263455967290619</c:v>
                  </c:pt>
                  <c:pt idx="42">
                    <c:v>4.3133513652379357E-2</c:v>
                  </c:pt>
                  <c:pt idx="43">
                    <c:v>5.6568542494923853E-3</c:v>
                  </c:pt>
                </c:numCache>
              </c:numRef>
            </c:plus>
            <c:minus>
              <c:numRef>
                <c:f>Foglio1!$J$144:$J$187</c:f>
                <c:numCache>
                  <c:formatCode>General</c:formatCode>
                  <c:ptCount val="44"/>
                  <c:pt idx="0">
                    <c:v>7.4246212024587477E-2</c:v>
                  </c:pt>
                  <c:pt idx="1">
                    <c:v>5.0204581464244995E-2</c:v>
                  </c:pt>
                  <c:pt idx="2">
                    <c:v>0.3075914498161485</c:v>
                  </c:pt>
                  <c:pt idx="3">
                    <c:v>0.17253405460951765</c:v>
                  </c:pt>
                  <c:pt idx="4">
                    <c:v>6.0104076400856514E-2</c:v>
                  </c:pt>
                  <c:pt idx="5">
                    <c:v>0.21213203435596409</c:v>
                  </c:pt>
                  <c:pt idx="6">
                    <c:v>0.24819448019647808</c:v>
                  </c:pt>
                  <c:pt idx="7">
                    <c:v>0.28779245994292457</c:v>
                  </c:pt>
                  <c:pt idx="8">
                    <c:v>0.10223624601871889</c:v>
                  </c:pt>
                  <c:pt idx="9">
                    <c:v>0.10223624601871889</c:v>
                  </c:pt>
                  <c:pt idx="10">
                    <c:v>0</c:v>
                  </c:pt>
                  <c:pt idx="11">
                    <c:v>3.6062445840513956E-2</c:v>
                  </c:pt>
                  <c:pt idx="12">
                    <c:v>0.11879393923933958</c:v>
                  </c:pt>
                  <c:pt idx="13">
                    <c:v>0</c:v>
                  </c:pt>
                  <c:pt idx="14">
                    <c:v>0.24041630560342656</c:v>
                  </c:pt>
                  <c:pt idx="15">
                    <c:v>7.0710678118654816E-4</c:v>
                  </c:pt>
                  <c:pt idx="16">
                    <c:v>0</c:v>
                  </c:pt>
                  <c:pt idx="17">
                    <c:v>2.8284271247461849E-2</c:v>
                  </c:pt>
                  <c:pt idx="18">
                    <c:v>0</c:v>
                  </c:pt>
                  <c:pt idx="19">
                    <c:v>0.17606958851545093</c:v>
                  </c:pt>
                  <c:pt idx="20">
                    <c:v>5.2325901807804484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17606958851545093</c:v>
                  </c:pt>
                  <c:pt idx="24">
                    <c:v>0</c:v>
                  </c:pt>
                  <c:pt idx="25">
                    <c:v>9.1923881554251269E-3</c:v>
                  </c:pt>
                  <c:pt idx="26">
                    <c:v>4.030508652763317E-2</c:v>
                  </c:pt>
                  <c:pt idx="27">
                    <c:v>2.8284271247461926E-2</c:v>
                  </c:pt>
                  <c:pt idx="28">
                    <c:v>2.2627416997969461E-2</c:v>
                  </c:pt>
                  <c:pt idx="29">
                    <c:v>0</c:v>
                  </c:pt>
                  <c:pt idx="30">
                    <c:v>0.12020815280171339</c:v>
                  </c:pt>
                  <c:pt idx="31">
                    <c:v>0.19940411229460603</c:v>
                  </c:pt>
                  <c:pt idx="32">
                    <c:v>0.17253405460951732</c:v>
                  </c:pt>
                  <c:pt idx="33">
                    <c:v>0</c:v>
                  </c:pt>
                  <c:pt idx="34">
                    <c:v>0.22698127676088156</c:v>
                  </c:pt>
                  <c:pt idx="35">
                    <c:v>0.1209152595828995</c:v>
                  </c:pt>
                  <c:pt idx="36">
                    <c:v>0.22132442251138984</c:v>
                  </c:pt>
                  <c:pt idx="37">
                    <c:v>6.5760930650348895E-2</c:v>
                  </c:pt>
                  <c:pt idx="38">
                    <c:v>3.0405591591021571E-2</c:v>
                  </c:pt>
                  <c:pt idx="39">
                    <c:v>1.2020815280171319E-2</c:v>
                  </c:pt>
                  <c:pt idx="40">
                    <c:v>0.21778888860545645</c:v>
                  </c:pt>
                  <c:pt idx="41">
                    <c:v>0.16263455967290619</c:v>
                  </c:pt>
                  <c:pt idx="42">
                    <c:v>4.3133513652379357E-2</c:v>
                  </c:pt>
                  <c:pt idx="43">
                    <c:v>5.656854249492385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I$193:$I$235</c:f>
              <c:strCache>
                <c:ptCount val="43"/>
                <c:pt idx="0">
                  <c:v>gS4b</c:v>
                </c:pt>
                <c:pt idx="1">
                  <c:v>wF10b</c:v>
                </c:pt>
                <c:pt idx="2">
                  <c:v>gCF2a</c:v>
                </c:pt>
                <c:pt idx="3">
                  <c:v>wF5a</c:v>
                </c:pt>
                <c:pt idx="4">
                  <c:v>gCS2a</c:v>
                </c:pt>
                <c:pt idx="5">
                  <c:v>wF5c</c:v>
                </c:pt>
                <c:pt idx="6">
                  <c:v>gCS5a</c:v>
                </c:pt>
                <c:pt idx="7">
                  <c:v>wF12b</c:v>
                </c:pt>
                <c:pt idx="8">
                  <c:v>wF12c</c:v>
                </c:pt>
                <c:pt idx="9">
                  <c:v>wF7c</c:v>
                </c:pt>
                <c:pt idx="10">
                  <c:v>wV1a</c:v>
                </c:pt>
                <c:pt idx="11">
                  <c:v>gS4c</c:v>
                </c:pt>
                <c:pt idx="12">
                  <c:v>gS3a</c:v>
                </c:pt>
                <c:pt idx="13">
                  <c:v>gCS6a</c:v>
                </c:pt>
                <c:pt idx="14">
                  <c:v>wF11d</c:v>
                </c:pt>
                <c:pt idx="15">
                  <c:v>wF7a</c:v>
                </c:pt>
                <c:pt idx="16">
                  <c:v>wF5b</c:v>
                </c:pt>
                <c:pt idx="17">
                  <c:v>wF10a</c:v>
                </c:pt>
                <c:pt idx="18">
                  <c:v>106</c:v>
                </c:pt>
                <c:pt idx="19">
                  <c:v>6707</c:v>
                </c:pt>
                <c:pt idx="20">
                  <c:v>6710</c:v>
                </c:pt>
                <c:pt idx="21">
                  <c:v>C21.4</c:v>
                </c:pt>
                <c:pt idx="22">
                  <c:v>C21.6</c:v>
                </c:pt>
                <c:pt idx="23">
                  <c:v>C21.1t1</c:v>
                </c:pt>
                <c:pt idx="24">
                  <c:v>C2.3</c:v>
                </c:pt>
                <c:pt idx="25">
                  <c:v>M1.</c:v>
                </c:pt>
                <c:pt idx="26">
                  <c:v>M4.</c:v>
                </c:pt>
                <c:pt idx="27">
                  <c:v>M5.</c:v>
                </c:pt>
                <c:pt idx="28">
                  <c:v>M6.</c:v>
                </c:pt>
                <c:pt idx="29">
                  <c:v>M12.</c:v>
                </c:pt>
                <c:pt idx="30">
                  <c:v>M11.</c:v>
                </c:pt>
                <c:pt idx="31">
                  <c:v>EB1G</c:v>
                </c:pt>
                <c:pt idx="32">
                  <c:v>EB1P</c:v>
                </c:pt>
                <c:pt idx="33">
                  <c:v>G3</c:v>
                </c:pt>
                <c:pt idx="34">
                  <c:v>G9</c:v>
                </c:pt>
                <c:pt idx="35">
                  <c:v>F6</c:v>
                </c:pt>
                <c:pt idx="36">
                  <c:v>F10</c:v>
                </c:pt>
                <c:pt idx="37">
                  <c:v>F32</c:v>
                </c:pt>
                <c:pt idx="38">
                  <c:v>F43</c:v>
                </c:pt>
                <c:pt idx="39">
                  <c:v>F14</c:v>
                </c:pt>
                <c:pt idx="40">
                  <c:v>F17</c:v>
                </c:pt>
                <c:pt idx="41">
                  <c:v>F22</c:v>
                </c:pt>
                <c:pt idx="42">
                  <c:v>F38</c:v>
                </c:pt>
              </c:strCache>
            </c:strRef>
          </c:cat>
          <c:val>
            <c:numRef>
              <c:f>Foglio1!$J$193:$J$235</c:f>
              <c:numCache>
                <c:formatCode>General</c:formatCode>
                <c:ptCount val="43"/>
                <c:pt idx="0">
                  <c:v>1.1895</c:v>
                </c:pt>
                <c:pt idx="1">
                  <c:v>0.98449999999999993</c:v>
                </c:pt>
                <c:pt idx="2">
                  <c:v>0.91400000000000003</c:v>
                </c:pt>
                <c:pt idx="3">
                  <c:v>0.91400000000000003</c:v>
                </c:pt>
                <c:pt idx="4">
                  <c:v>1.236</c:v>
                </c:pt>
                <c:pt idx="5">
                  <c:v>1.2375</c:v>
                </c:pt>
                <c:pt idx="6">
                  <c:v>0.91850000000000009</c:v>
                </c:pt>
                <c:pt idx="7">
                  <c:v>0.75350000000000006</c:v>
                </c:pt>
                <c:pt idx="8">
                  <c:v>0.75350000000000006</c:v>
                </c:pt>
                <c:pt idx="9">
                  <c:v>0.93400000000000005</c:v>
                </c:pt>
                <c:pt idx="10">
                  <c:v>0.86050000000000004</c:v>
                </c:pt>
                <c:pt idx="11">
                  <c:v>0.79800000000000004</c:v>
                </c:pt>
                <c:pt idx="12">
                  <c:v>1.5640000000000001</c:v>
                </c:pt>
                <c:pt idx="13">
                  <c:v>0.60899999999999999</c:v>
                </c:pt>
                <c:pt idx="14">
                  <c:v>0.89549999999999996</c:v>
                </c:pt>
                <c:pt idx="15">
                  <c:v>0.874</c:v>
                </c:pt>
                <c:pt idx="16">
                  <c:v>0.92199999999999993</c:v>
                </c:pt>
                <c:pt idx="17">
                  <c:v>1.2230000000000001</c:v>
                </c:pt>
                <c:pt idx="18">
                  <c:v>0.58000000000000007</c:v>
                </c:pt>
                <c:pt idx="19">
                  <c:v>0.76449999999999996</c:v>
                </c:pt>
                <c:pt idx="20">
                  <c:v>0.93200000000000005</c:v>
                </c:pt>
                <c:pt idx="21">
                  <c:v>0.85549999999999993</c:v>
                </c:pt>
                <c:pt idx="22">
                  <c:v>0.35799999999999998</c:v>
                </c:pt>
                <c:pt idx="23">
                  <c:v>0.76550000000000007</c:v>
                </c:pt>
                <c:pt idx="24">
                  <c:v>0.71050000000000002</c:v>
                </c:pt>
                <c:pt idx="25">
                  <c:v>0.96399999999999997</c:v>
                </c:pt>
                <c:pt idx="26">
                  <c:v>0.67900000000000005</c:v>
                </c:pt>
                <c:pt idx="27">
                  <c:v>0.71099999999999997</c:v>
                </c:pt>
                <c:pt idx="28">
                  <c:v>0.79099999999999993</c:v>
                </c:pt>
                <c:pt idx="29">
                  <c:v>0.83099999999999996</c:v>
                </c:pt>
                <c:pt idx="30">
                  <c:v>0.64400000000000002</c:v>
                </c:pt>
                <c:pt idx="31">
                  <c:v>0.90600000000000003</c:v>
                </c:pt>
                <c:pt idx="32">
                  <c:v>2.2195</c:v>
                </c:pt>
                <c:pt idx="33">
                  <c:v>2.1215000000000002</c:v>
                </c:pt>
                <c:pt idx="34">
                  <c:v>0.88100000000000001</c:v>
                </c:pt>
                <c:pt idx="35">
                  <c:v>0.75049999999999994</c:v>
                </c:pt>
                <c:pt idx="36">
                  <c:v>1.1495</c:v>
                </c:pt>
                <c:pt idx="37">
                  <c:v>0.64850000000000008</c:v>
                </c:pt>
                <c:pt idx="38">
                  <c:v>0.66749999999999998</c:v>
                </c:pt>
                <c:pt idx="39">
                  <c:v>0.75600000000000001</c:v>
                </c:pt>
                <c:pt idx="40">
                  <c:v>0.876</c:v>
                </c:pt>
                <c:pt idx="41">
                  <c:v>0.94450000000000001</c:v>
                </c:pt>
                <c:pt idx="42">
                  <c:v>0.506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572B-4D39-8FC7-A4C160B99E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9572624"/>
        <c:axId val="379571184"/>
      </c:barChart>
      <c:catAx>
        <c:axId val="37957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9571184"/>
        <c:crosses val="autoZero"/>
        <c:auto val="1"/>
        <c:lblAlgn val="ctr"/>
        <c:lblOffset val="100"/>
        <c:noMultiLvlLbl val="0"/>
      </c:catAx>
      <c:valAx>
        <c:axId val="3795711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95726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dirty="0"/>
              <a:t>Volatile </a:t>
            </a:r>
            <a:r>
              <a:rPr lang="it-IT" dirty="0" err="1"/>
              <a:t>acidity</a:t>
            </a:r>
            <a:endParaRPr lang="it-IT" dirty="0"/>
          </a:p>
          <a:p>
            <a:pPr>
              <a:defRPr/>
            </a:pPr>
            <a:r>
              <a:rPr lang="it-IT" dirty="0"/>
              <a:t>(g/L </a:t>
            </a:r>
            <a:r>
              <a:rPr lang="it-IT" dirty="0" err="1"/>
              <a:t>acetic</a:t>
            </a:r>
            <a:r>
              <a:rPr lang="it-IT" dirty="0"/>
              <a:t> acid) </a:t>
            </a:r>
          </a:p>
          <a:p>
            <a:pPr>
              <a:defRPr/>
            </a:pPr>
            <a:endParaRPr lang="it-IT" dirty="0"/>
          </a:p>
        </c:rich>
      </c:tx>
      <c:layout>
        <c:manualLayout>
          <c:xMode val="edge"/>
          <c:yMode val="edge"/>
          <c:x val="0.44022725349482883"/>
          <c:y val="1.92189538230585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948-43ED-B560-DB2621F34C86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948-43ED-B560-DB2621F34C86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948-43ED-B560-DB2621F34C86}"/>
              </c:ext>
            </c:extLst>
          </c:dPt>
          <c:dPt>
            <c:idx val="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948-43ED-B560-DB2621F34C86}"/>
              </c:ext>
            </c:extLst>
          </c:dPt>
          <c:dPt>
            <c:idx val="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948-43ED-B560-DB2621F34C86}"/>
              </c:ext>
            </c:extLst>
          </c:dPt>
          <c:dPt>
            <c:idx val="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948-43ED-B560-DB2621F34C86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948-43ED-B560-DB2621F34C86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948-43ED-B560-DB2621F34C86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7948-43ED-B560-DB2621F34C86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7948-43ED-B560-DB2621F34C86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7948-43ED-B560-DB2621F34C86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7948-43ED-B560-DB2621F34C86}"/>
              </c:ext>
            </c:extLst>
          </c:dPt>
          <c:dPt>
            <c:idx val="12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7948-43ED-B560-DB2621F34C86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7948-43ED-B560-DB2621F34C86}"/>
              </c:ext>
            </c:extLst>
          </c:dPt>
          <c:dPt>
            <c:idx val="14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7948-43ED-B560-DB2621F34C86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7948-43ED-B560-DB2621F34C86}"/>
              </c:ext>
            </c:extLst>
          </c:dPt>
          <c:dPt>
            <c:idx val="16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7948-43ED-B560-DB2621F34C86}"/>
              </c:ext>
            </c:extLst>
          </c:dPt>
          <c:dPt>
            <c:idx val="17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7948-43ED-B560-DB2621F34C86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7948-43ED-B560-DB2621F34C86}"/>
              </c:ext>
            </c:extLst>
          </c:dPt>
          <c:dPt>
            <c:idx val="19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7948-43ED-B560-DB2621F34C86}"/>
              </c:ext>
            </c:extLst>
          </c:dPt>
          <c:dPt>
            <c:idx val="2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7948-43ED-B560-DB2621F34C86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7948-43ED-B560-DB2621F34C86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7948-43ED-B560-DB2621F34C86}"/>
              </c:ext>
            </c:extLst>
          </c:dPt>
          <c:dPt>
            <c:idx val="2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7948-43ED-B560-DB2621F34C86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7948-43ED-B560-DB2621F34C86}"/>
              </c:ext>
            </c:extLst>
          </c:dPt>
          <c:dPt>
            <c:idx val="2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2-A63E-4539-B20A-A892F8C6164D}"/>
              </c:ext>
            </c:extLst>
          </c:dPt>
          <c:dPt>
            <c:idx val="26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7948-43ED-B560-DB2621F34C86}"/>
              </c:ext>
            </c:extLst>
          </c:dPt>
          <c:dPt>
            <c:idx val="27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7948-43ED-B560-DB2621F34C86}"/>
              </c:ext>
            </c:extLst>
          </c:dPt>
          <c:dPt>
            <c:idx val="28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7948-43ED-B560-DB2621F34C86}"/>
              </c:ext>
            </c:extLst>
          </c:dPt>
          <c:dPt>
            <c:idx val="29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9-7948-43ED-B560-DB2621F34C86}"/>
              </c:ext>
            </c:extLst>
          </c:dPt>
          <c:dPt>
            <c:idx val="3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B-7948-43ED-B560-DB2621F34C86}"/>
              </c:ext>
            </c:extLst>
          </c:dPt>
          <c:dPt>
            <c:idx val="31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D-7948-43ED-B560-DB2621F34C86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F-7948-43ED-B560-DB2621F34C86}"/>
              </c:ext>
            </c:extLst>
          </c:dPt>
          <c:dPt>
            <c:idx val="3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1-7948-43ED-B560-DB2621F34C86}"/>
              </c:ext>
            </c:extLst>
          </c:dPt>
          <c:dPt>
            <c:idx val="36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3-7948-43ED-B560-DB2621F34C86}"/>
              </c:ext>
            </c:extLst>
          </c:dPt>
          <c:dPt>
            <c:idx val="37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5-7948-43ED-B560-DB2621F34C86}"/>
              </c:ext>
            </c:extLst>
          </c:dPt>
          <c:dPt>
            <c:idx val="38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7-7948-43ED-B560-DB2621F34C86}"/>
              </c:ext>
            </c:extLst>
          </c:dPt>
          <c:dPt>
            <c:idx val="39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9-7948-43ED-B560-DB2621F34C86}"/>
              </c:ext>
            </c:extLst>
          </c:dPt>
          <c:dPt>
            <c:idx val="40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B-7948-43ED-B560-DB2621F34C86}"/>
              </c:ext>
            </c:extLst>
          </c:dPt>
          <c:dPt>
            <c:idx val="41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D-7948-43ED-B560-DB2621F34C86}"/>
              </c:ext>
            </c:extLst>
          </c:dPt>
          <c:dPt>
            <c:idx val="42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4F-7948-43ED-B560-DB2621F34C86}"/>
              </c:ext>
            </c:extLst>
          </c:dPt>
          <c:dPt>
            <c:idx val="43"/>
            <c:invertIfNegative val="0"/>
            <c:bubble3D val="0"/>
            <c:spPr>
              <a:solidFill>
                <a:srgbClr val="7030A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51-7948-43ED-B560-DB2621F34C86}"/>
              </c:ext>
            </c:extLst>
          </c:dPt>
          <c:errBars>
            <c:errBarType val="both"/>
            <c:errValType val="cust"/>
            <c:noEndCap val="0"/>
            <c:plus>
              <c:numRef>
                <c:f>Foglio1!$L$144:$L$187</c:f>
                <c:numCache>
                  <c:formatCode>General</c:formatCode>
                  <c:ptCount val="44"/>
                  <c:pt idx="0">
                    <c:v>7.778174593052108E-3</c:v>
                  </c:pt>
                  <c:pt idx="1">
                    <c:v>3.5355339059327411E-2</c:v>
                  </c:pt>
                  <c:pt idx="2">
                    <c:v>4.949747468305829E-2</c:v>
                  </c:pt>
                  <c:pt idx="3">
                    <c:v>8.4852813742385708E-2</c:v>
                  </c:pt>
                  <c:pt idx="4">
                    <c:v>2.1213203435596444E-2</c:v>
                  </c:pt>
                  <c:pt idx="5">
                    <c:v>0</c:v>
                  </c:pt>
                  <c:pt idx="6">
                    <c:v>2.8284271247461926E-2</c:v>
                  </c:pt>
                  <c:pt idx="7">
                    <c:v>0</c:v>
                  </c:pt>
                  <c:pt idx="8">
                    <c:v>0.19949937343259982</c:v>
                  </c:pt>
                  <c:pt idx="9">
                    <c:v>0.19949937343259982</c:v>
                  </c:pt>
                  <c:pt idx="10">
                    <c:v>0</c:v>
                  </c:pt>
                  <c:pt idx="11">
                    <c:v>0.18384776310850251</c:v>
                  </c:pt>
                  <c:pt idx="12">
                    <c:v>4.9497474683058332E-2</c:v>
                  </c:pt>
                  <c:pt idx="13">
                    <c:v>0</c:v>
                  </c:pt>
                  <c:pt idx="14">
                    <c:v>7.0710678118654655E-2</c:v>
                  </c:pt>
                  <c:pt idx="15">
                    <c:v>4.9497474683058366E-2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8.4852813742385708E-2</c:v>
                  </c:pt>
                  <c:pt idx="20">
                    <c:v>9.899494936611658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2.8284271247461926E-2</c:v>
                  </c:pt>
                  <c:pt idx="24">
                    <c:v>0</c:v>
                  </c:pt>
                  <c:pt idx="25">
                    <c:v>0.1131370849898477</c:v>
                  </c:pt>
                  <c:pt idx="26">
                    <c:v>0.24041630560342678</c:v>
                  </c:pt>
                  <c:pt idx="27">
                    <c:v>0.16970562748477122</c:v>
                  </c:pt>
                  <c:pt idx="28">
                    <c:v>9.899494936611658E-2</c:v>
                  </c:pt>
                  <c:pt idx="29">
                    <c:v>0</c:v>
                  </c:pt>
                  <c:pt idx="30">
                    <c:v>0.12020815280171303</c:v>
                  </c:pt>
                  <c:pt idx="31">
                    <c:v>0.16970562748477122</c:v>
                  </c:pt>
                  <c:pt idx="32">
                    <c:v>8.4852813742385777E-2</c:v>
                  </c:pt>
                  <c:pt idx="33">
                    <c:v>0</c:v>
                  </c:pt>
                  <c:pt idx="34">
                    <c:v>0.14849242404917495</c:v>
                  </c:pt>
                  <c:pt idx="35">
                    <c:v>2.1213203435596444E-2</c:v>
                  </c:pt>
                  <c:pt idx="36">
                    <c:v>1.4142135623730963E-2</c:v>
                  </c:pt>
                  <c:pt idx="37">
                    <c:v>4.949747468305829E-2</c:v>
                  </c:pt>
                  <c:pt idx="38">
                    <c:v>8.4852813742385777E-2</c:v>
                  </c:pt>
                  <c:pt idx="39">
                    <c:v>7.0710678118654821E-2</c:v>
                  </c:pt>
                  <c:pt idx="40">
                    <c:v>8.4852813742385777E-2</c:v>
                  </c:pt>
                  <c:pt idx="41">
                    <c:v>7.0710678118678365E-4</c:v>
                  </c:pt>
                  <c:pt idx="42">
                    <c:v>0.26870057685088816</c:v>
                  </c:pt>
                  <c:pt idx="43">
                    <c:v>0.23334523779156041</c:v>
                  </c:pt>
                </c:numCache>
              </c:numRef>
            </c:plus>
            <c:minus>
              <c:numRef>
                <c:f>Foglio1!$L$144:$L$187</c:f>
                <c:numCache>
                  <c:formatCode>General</c:formatCode>
                  <c:ptCount val="44"/>
                  <c:pt idx="0">
                    <c:v>7.778174593052108E-3</c:v>
                  </c:pt>
                  <c:pt idx="1">
                    <c:v>3.5355339059327411E-2</c:v>
                  </c:pt>
                  <c:pt idx="2">
                    <c:v>4.949747468305829E-2</c:v>
                  </c:pt>
                  <c:pt idx="3">
                    <c:v>8.4852813742385708E-2</c:v>
                  </c:pt>
                  <c:pt idx="4">
                    <c:v>2.1213203435596444E-2</c:v>
                  </c:pt>
                  <c:pt idx="5">
                    <c:v>0</c:v>
                  </c:pt>
                  <c:pt idx="6">
                    <c:v>2.8284271247461926E-2</c:v>
                  </c:pt>
                  <c:pt idx="7">
                    <c:v>0</c:v>
                  </c:pt>
                  <c:pt idx="8">
                    <c:v>0.19949937343259982</c:v>
                  </c:pt>
                  <c:pt idx="9">
                    <c:v>0.19949937343259982</c:v>
                  </c:pt>
                  <c:pt idx="10">
                    <c:v>0</c:v>
                  </c:pt>
                  <c:pt idx="11">
                    <c:v>0.18384776310850251</c:v>
                  </c:pt>
                  <c:pt idx="12">
                    <c:v>4.9497474683058332E-2</c:v>
                  </c:pt>
                  <c:pt idx="13">
                    <c:v>0</c:v>
                  </c:pt>
                  <c:pt idx="14">
                    <c:v>7.0710678118654655E-2</c:v>
                  </c:pt>
                  <c:pt idx="15">
                    <c:v>4.9497474683058366E-2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8.4852813742385708E-2</c:v>
                  </c:pt>
                  <c:pt idx="20">
                    <c:v>9.899494936611658E-2</c:v>
                  </c:pt>
                  <c:pt idx="21">
                    <c:v>0</c:v>
                  </c:pt>
                  <c:pt idx="22">
                    <c:v>0</c:v>
                  </c:pt>
                  <c:pt idx="23">
                    <c:v>2.8284271247461926E-2</c:v>
                  </c:pt>
                  <c:pt idx="24">
                    <c:v>0</c:v>
                  </c:pt>
                  <c:pt idx="25">
                    <c:v>0.1131370849898477</c:v>
                  </c:pt>
                  <c:pt idx="26">
                    <c:v>0.24041630560342678</c:v>
                  </c:pt>
                  <c:pt idx="27">
                    <c:v>0.16970562748477122</c:v>
                  </c:pt>
                  <c:pt idx="28">
                    <c:v>9.899494936611658E-2</c:v>
                  </c:pt>
                  <c:pt idx="29">
                    <c:v>0</c:v>
                  </c:pt>
                  <c:pt idx="30">
                    <c:v>0.12020815280171303</c:v>
                  </c:pt>
                  <c:pt idx="31">
                    <c:v>0.16970562748477122</c:v>
                  </c:pt>
                  <c:pt idx="32">
                    <c:v>8.4852813742385777E-2</c:v>
                  </c:pt>
                  <c:pt idx="33">
                    <c:v>0</c:v>
                  </c:pt>
                  <c:pt idx="34">
                    <c:v>0.14849242404917495</c:v>
                  </c:pt>
                  <c:pt idx="35">
                    <c:v>2.1213203435596444E-2</c:v>
                  </c:pt>
                  <c:pt idx="36">
                    <c:v>1.4142135623730963E-2</c:v>
                  </c:pt>
                  <c:pt idx="37">
                    <c:v>4.949747468305829E-2</c:v>
                  </c:pt>
                  <c:pt idx="38">
                    <c:v>8.4852813742385777E-2</c:v>
                  </c:pt>
                  <c:pt idx="39">
                    <c:v>7.0710678118654821E-2</c:v>
                  </c:pt>
                  <c:pt idx="40">
                    <c:v>8.4852813742385777E-2</c:v>
                  </c:pt>
                  <c:pt idx="41">
                    <c:v>7.0710678118678365E-4</c:v>
                  </c:pt>
                  <c:pt idx="42">
                    <c:v>0.26870057685088816</c:v>
                  </c:pt>
                  <c:pt idx="43">
                    <c:v>0.233345237791560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I$240:$I$283</c:f>
              <c:strCache>
                <c:ptCount val="44"/>
                <c:pt idx="0">
                  <c:v>gCS1a</c:v>
                </c:pt>
                <c:pt idx="1">
                  <c:v>gS4b</c:v>
                </c:pt>
                <c:pt idx="2">
                  <c:v>wF10b</c:v>
                </c:pt>
                <c:pt idx="3">
                  <c:v>gCF2a</c:v>
                </c:pt>
                <c:pt idx="4">
                  <c:v>wF5a</c:v>
                </c:pt>
                <c:pt idx="5">
                  <c:v>gCS2a</c:v>
                </c:pt>
                <c:pt idx="6">
                  <c:v>wF5c</c:v>
                </c:pt>
                <c:pt idx="7">
                  <c:v>gCS5a</c:v>
                </c:pt>
                <c:pt idx="8">
                  <c:v>wF12b</c:v>
                </c:pt>
                <c:pt idx="9">
                  <c:v>wF12c</c:v>
                </c:pt>
                <c:pt idx="10">
                  <c:v>wF7c</c:v>
                </c:pt>
                <c:pt idx="11">
                  <c:v>wV1a</c:v>
                </c:pt>
                <c:pt idx="12">
                  <c:v>gS4c</c:v>
                </c:pt>
                <c:pt idx="13">
                  <c:v>gS3a</c:v>
                </c:pt>
                <c:pt idx="14">
                  <c:v>gCS6a</c:v>
                </c:pt>
                <c:pt idx="15">
                  <c:v>wF11d</c:v>
                </c:pt>
                <c:pt idx="16">
                  <c:v>wF7a</c:v>
                </c:pt>
                <c:pt idx="17">
                  <c:v>wF5b</c:v>
                </c:pt>
                <c:pt idx="18">
                  <c:v>wF10a</c:v>
                </c:pt>
                <c:pt idx="19">
                  <c:v>106</c:v>
                </c:pt>
                <c:pt idx="20">
                  <c:v>6707</c:v>
                </c:pt>
                <c:pt idx="21">
                  <c:v>6710</c:v>
                </c:pt>
                <c:pt idx="22">
                  <c:v>C21.4</c:v>
                </c:pt>
                <c:pt idx="23">
                  <c:v>C21.6</c:v>
                </c:pt>
                <c:pt idx="24">
                  <c:v>C21.1t1</c:v>
                </c:pt>
                <c:pt idx="25">
                  <c:v>C2.3</c:v>
                </c:pt>
                <c:pt idx="26">
                  <c:v>M1.</c:v>
                </c:pt>
                <c:pt idx="27">
                  <c:v>M4.</c:v>
                </c:pt>
                <c:pt idx="28">
                  <c:v>M5.</c:v>
                </c:pt>
                <c:pt idx="29">
                  <c:v>M6.</c:v>
                </c:pt>
                <c:pt idx="30">
                  <c:v>M12.</c:v>
                </c:pt>
                <c:pt idx="31">
                  <c:v>M11.</c:v>
                </c:pt>
                <c:pt idx="32">
                  <c:v>EB1G</c:v>
                </c:pt>
                <c:pt idx="33">
                  <c:v>EB1P</c:v>
                </c:pt>
                <c:pt idx="34">
                  <c:v>G3</c:v>
                </c:pt>
                <c:pt idx="35">
                  <c:v>G9</c:v>
                </c:pt>
                <c:pt idx="36">
                  <c:v>F6</c:v>
                </c:pt>
                <c:pt idx="37">
                  <c:v>F10</c:v>
                </c:pt>
                <c:pt idx="38">
                  <c:v>F32</c:v>
                </c:pt>
                <c:pt idx="39">
                  <c:v>F43</c:v>
                </c:pt>
                <c:pt idx="40">
                  <c:v>F14</c:v>
                </c:pt>
                <c:pt idx="41">
                  <c:v>F17</c:v>
                </c:pt>
                <c:pt idx="42">
                  <c:v>F22</c:v>
                </c:pt>
                <c:pt idx="43">
                  <c:v>F38</c:v>
                </c:pt>
              </c:strCache>
            </c:strRef>
          </c:cat>
          <c:val>
            <c:numRef>
              <c:f>Foglio1!$J$240:$J$283</c:f>
              <c:numCache>
                <c:formatCode>General</c:formatCode>
                <c:ptCount val="44"/>
                <c:pt idx="0">
                  <c:v>1.0545</c:v>
                </c:pt>
                <c:pt idx="1">
                  <c:v>1.0350000000000001</c:v>
                </c:pt>
                <c:pt idx="2">
                  <c:v>0.82499999999999996</c:v>
                </c:pt>
                <c:pt idx="3">
                  <c:v>0.6100000000000001</c:v>
                </c:pt>
                <c:pt idx="4">
                  <c:v>0.6100000000000001</c:v>
                </c:pt>
                <c:pt idx="5">
                  <c:v>1.1299999999999999</c:v>
                </c:pt>
                <c:pt idx="6">
                  <c:v>1.44</c:v>
                </c:pt>
                <c:pt idx="7">
                  <c:v>1.85</c:v>
                </c:pt>
                <c:pt idx="8">
                  <c:v>0.84</c:v>
                </c:pt>
                <c:pt idx="9">
                  <c:v>0.84</c:v>
                </c:pt>
                <c:pt idx="10">
                  <c:v>1.1299999999999999</c:v>
                </c:pt>
                <c:pt idx="11">
                  <c:v>0.73</c:v>
                </c:pt>
                <c:pt idx="12">
                  <c:v>0.495</c:v>
                </c:pt>
                <c:pt idx="13">
                  <c:v>0.7</c:v>
                </c:pt>
                <c:pt idx="14">
                  <c:v>1.37</c:v>
                </c:pt>
                <c:pt idx="15">
                  <c:v>0.755</c:v>
                </c:pt>
                <c:pt idx="16">
                  <c:v>2.74</c:v>
                </c:pt>
                <c:pt idx="17">
                  <c:v>0.82</c:v>
                </c:pt>
                <c:pt idx="18">
                  <c:v>0.79</c:v>
                </c:pt>
                <c:pt idx="19">
                  <c:v>1.6800000000000002</c:v>
                </c:pt>
                <c:pt idx="20">
                  <c:v>0.6399999999999999</c:v>
                </c:pt>
                <c:pt idx="21">
                  <c:v>1.2</c:v>
                </c:pt>
                <c:pt idx="22">
                  <c:v>0.96599999999999997</c:v>
                </c:pt>
                <c:pt idx="23">
                  <c:v>0.79</c:v>
                </c:pt>
                <c:pt idx="24">
                  <c:v>2.34</c:v>
                </c:pt>
                <c:pt idx="25">
                  <c:v>1.1499999999999999</c:v>
                </c:pt>
                <c:pt idx="26">
                  <c:v>0.72</c:v>
                </c:pt>
                <c:pt idx="27">
                  <c:v>1.1499999999999999</c:v>
                </c:pt>
                <c:pt idx="28">
                  <c:v>1.39</c:v>
                </c:pt>
                <c:pt idx="29">
                  <c:v>1.115</c:v>
                </c:pt>
                <c:pt idx="30">
                  <c:v>0.91</c:v>
                </c:pt>
                <c:pt idx="31">
                  <c:v>1.96</c:v>
                </c:pt>
                <c:pt idx="32">
                  <c:v>2.09</c:v>
                </c:pt>
                <c:pt idx="33">
                  <c:v>2.1949999999999998</c:v>
                </c:pt>
                <c:pt idx="34">
                  <c:v>0.995</c:v>
                </c:pt>
                <c:pt idx="35">
                  <c:v>1.3</c:v>
                </c:pt>
                <c:pt idx="36">
                  <c:v>0.61</c:v>
                </c:pt>
                <c:pt idx="37">
                  <c:v>0.58499999999999996</c:v>
                </c:pt>
                <c:pt idx="38">
                  <c:v>1.48</c:v>
                </c:pt>
                <c:pt idx="39">
                  <c:v>0.87</c:v>
                </c:pt>
                <c:pt idx="40">
                  <c:v>2.58</c:v>
                </c:pt>
                <c:pt idx="41">
                  <c:v>2.4935</c:v>
                </c:pt>
                <c:pt idx="42">
                  <c:v>1.08</c:v>
                </c:pt>
                <c:pt idx="43">
                  <c:v>2.615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2-7948-43ED-B560-DB2621F34C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31062952"/>
        <c:axId val="831063312"/>
      </c:barChart>
      <c:catAx>
        <c:axId val="831062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31063312"/>
        <c:crosses val="autoZero"/>
        <c:auto val="1"/>
        <c:lblAlgn val="ctr"/>
        <c:lblOffset val="100"/>
        <c:noMultiLvlLbl val="0"/>
      </c:catAx>
      <c:valAx>
        <c:axId val="8310633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3106295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495</cdr:x>
      <cdr:y>0.4056</cdr:y>
    </cdr:from>
    <cdr:to>
      <cdr:x>0.5505</cdr:x>
      <cdr:y>0.5944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F581F1CC-CBF4-E34F-AC2C-52F8B6C59A33}"/>
            </a:ext>
          </a:extLst>
        </cdr:cNvPr>
        <cdr:cNvSpPr txBox="1"/>
      </cdr:nvSpPr>
      <cdr:spPr>
        <a:xfrm xmlns:a="http://schemas.openxmlformats.org/drawingml/2006/main">
          <a:off x="4069371" y="1964502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baseline="-250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2060FC-6F56-B30C-04A1-B78E5BFB9C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1603608-4408-987C-ADD8-C8A40A9476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CBD8A74-5329-C752-113C-575AF10E4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FBE7950-D22D-D3C0-7944-33027DD49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635C0B5-95B6-518F-4CDE-281A9EE4E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6907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15668DD-6447-0B3C-510F-D2DB555B1A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604B873-59E2-5D0E-2DD2-186832F088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F82398-BB72-1F7A-D712-3FE4B7C4B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4DF83AB-B73C-5754-718C-A9FB20309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958B877-CC76-7330-29B2-B9A299273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6446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8964DE1-F730-FEDF-B808-C1E5F0922C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D731625-125B-6780-6179-E1887D5219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772E82-8B9F-FF4F-CEBE-2D4A14457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0AB641D-B6F3-DA3C-C3B1-52E5B3E21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09D5188-2D94-5575-C068-AA70F5613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0973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3FB09D3-AA77-FAEC-12F6-FEDC187BEC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9F7791E-96C3-325E-5340-012BB001B7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5E0F4FD-D0F1-1438-1ECB-7DC60D428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8AE1932-4E05-01D3-FA53-02C322B84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98CDC9-056F-1308-0940-5C8B89F15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0509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E5741C-1A01-98CF-070B-DCB5D9F21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CF0BD4E-32B7-266B-CF2A-A5B48B098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D8C5333-E6FD-6FEA-CCB1-813D24B80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9C4D414-6E7C-D5EC-3806-158E70FA1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7F51CC9-8FD0-FDC6-0A25-CA9E1C5CE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2697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0B6189-265B-A08A-9C92-6B4C0F79AD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34903A4-B937-2834-5CDD-BA3A9F7DF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2081135-79FC-C87E-E9D7-8B4373C41C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AF6F94F-F7E8-59BF-7DA7-DC78179F5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8E3E050-70D8-F459-7109-E61EE7D31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339C904-5F9E-5417-F013-AC4298E4F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4324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C47DD2-89D5-185C-F296-892F69B83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3828B3D-3F57-4B99-E79D-A096AE3FE8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089BA9B-A549-3E8E-B7E4-0B1B32AAA0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E05FC33-2CC1-4A97-6C70-F86F19400B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6BBDEAC-5F18-935F-F876-98E9FFB8E0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26F820E-8031-DE1D-4739-FA5283531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DD177E9-2C90-5C5A-A76D-09F7BC818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634B5E3-A956-6553-2619-99D63F1D0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3107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088902-704B-9CEF-8663-5741AD5E02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BAA62E8-DBB7-1295-1ABE-F04F761D0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B99DBC3-DE37-FD75-2EBD-89CAC1020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AFCAB97-5C25-AB47-4424-2D02D349C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1573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56A339B-C063-E7AF-1E35-578E33553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929F59B-15EB-2E28-EC46-7E9EA0BB8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0B0D170-0110-85BF-53C3-F94B8635E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9635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2F47F49-5772-E4D4-A738-04993ACC0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511314A-F436-FD41-9031-A6CABA8E11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39C5E40-4F69-FFD5-49C4-12F12B6D24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A43A047-4511-B05C-34D9-716470817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5353534-BE06-CEE2-A04D-3BB8A26D2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BB0260A-1492-AF9C-214D-54AECA1BE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13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05D2499-95C5-07A1-2AF5-2C1839CFD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AF86E69-2A98-E156-FAF3-FD161A23AF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ABFB1CA-B1C6-6FED-C545-2189E8E49B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A199E3F-1484-060B-974B-3D0E892730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D51F227-3186-D2BD-B9EE-4BEAA3AA0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177A008-A017-62AC-2C58-94A594E68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5956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25834A9-4DF3-E753-5B39-9BED04D42F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B3FD647-48C7-A803-DD50-FEA2027CAE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9096C96-5832-B436-BA17-24D3CA63F2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4CE39-1A84-42AB-BCC6-A1677077A77C}" type="datetimeFigureOut">
              <a:rPr lang="it-IT" smtClean="0"/>
              <a:t>31/10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C285675-51C2-1EBF-3A23-09D199EBA9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170E194-DE7F-1620-A6CA-75FD40A866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ADC77-6279-4ADD-ADBB-8D5C56E16A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8722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9EC32D71-1F91-3099-1D22-F00192D99E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5837158"/>
              </p:ext>
            </p:extLst>
          </p:nvPr>
        </p:nvGraphicFramePr>
        <p:xfrm>
          <a:off x="1051348" y="1016635"/>
          <a:ext cx="9613541" cy="42085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22D0B2AF-2A18-0BBF-9DE1-9B6449B1BFFA}"/>
              </a:ext>
            </a:extLst>
          </p:cNvPr>
          <p:cNvSpPr txBox="1"/>
          <p:nvPr/>
        </p:nvSpPr>
        <p:spPr>
          <a:xfrm>
            <a:off x="9046813" y="1448191"/>
            <a:ext cx="281353" cy="369332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dirty="0">
                <a:ea typeface="Calibri"/>
                <a:cs typeface="Calibri"/>
              </a:rPr>
              <a:t>*</a:t>
            </a:r>
            <a:endParaRPr lang="it-IT" dirty="0"/>
          </a:p>
        </p:txBody>
      </p:sp>
      <p:sp>
        <p:nvSpPr>
          <p:cNvPr id="3" name="CasellaDiTesto 1">
            <a:extLst>
              <a:ext uri="{FF2B5EF4-FFF2-40B4-BE49-F238E27FC236}">
                <a16:creationId xmlns:a16="http://schemas.microsoft.com/office/drawing/2014/main" id="{22D0B2AF-2A18-0BBF-9DE1-9B6449B1BFFA}"/>
              </a:ext>
            </a:extLst>
          </p:cNvPr>
          <p:cNvSpPr txBox="1"/>
          <p:nvPr/>
        </p:nvSpPr>
        <p:spPr>
          <a:xfrm>
            <a:off x="2768585" y="3577312"/>
            <a:ext cx="281353" cy="369332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dirty="0">
                <a:ea typeface="Calibri"/>
                <a:cs typeface="Calibri"/>
              </a:rPr>
              <a:t>*</a:t>
            </a:r>
            <a:endParaRPr lang="it-IT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6A074E23-3448-8CE4-FB87-EBB4131499B8}"/>
              </a:ext>
            </a:extLst>
          </p:cNvPr>
          <p:cNvSpPr txBox="1"/>
          <p:nvPr/>
        </p:nvSpPr>
        <p:spPr>
          <a:xfrm>
            <a:off x="765110" y="74644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a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4FC5755A-597A-DC2C-96DC-1DE20D54DD55}"/>
              </a:ext>
            </a:extLst>
          </p:cNvPr>
          <p:cNvSpPr txBox="1"/>
          <p:nvPr/>
        </p:nvSpPr>
        <p:spPr>
          <a:xfrm>
            <a:off x="812021" y="5283460"/>
            <a:ext cx="10567958" cy="12238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 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ain oenological characters of  strains tested a) ethanol; b) fermentation rate; 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) ethyl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aico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d) ethyl phenols;  e)volatile acidity.</a:t>
            </a:r>
            <a:r>
              <a:rPr lang="it-IT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, significant difference (Fischer ANOVA; p-value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.05). 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4066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o 6">
            <a:extLst>
              <a:ext uri="{FF2B5EF4-FFF2-40B4-BE49-F238E27FC236}">
                <a16:creationId xmlns:a16="http://schemas.microsoft.com/office/drawing/2014/main" id="{2EFB9EB4-B77B-D3CE-85A5-FB7A35DEC793}"/>
              </a:ext>
            </a:extLst>
          </p:cNvPr>
          <p:cNvGrpSpPr/>
          <p:nvPr/>
        </p:nvGrpSpPr>
        <p:grpSpPr>
          <a:xfrm>
            <a:off x="1032589" y="671804"/>
            <a:ext cx="10126822" cy="4516016"/>
            <a:chOff x="1032589" y="671804"/>
            <a:chExt cx="10126822" cy="4516016"/>
          </a:xfrm>
        </p:grpSpPr>
        <p:graphicFrame>
          <p:nvGraphicFramePr>
            <p:cNvPr id="4" name="Grafico 3">
              <a:extLst>
                <a:ext uri="{FF2B5EF4-FFF2-40B4-BE49-F238E27FC236}">
                  <a16:creationId xmlns:a16="http://schemas.microsoft.com/office/drawing/2014/main" id="{342829E0-0DE0-A509-AE26-717164A8969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119672" y="671804"/>
            <a:ext cx="10039739" cy="45160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22D0B2AF-2A18-0BBF-9DE1-9B6449B1BFFA}"/>
                </a:ext>
              </a:extLst>
            </p:cNvPr>
            <p:cNvSpPr txBox="1"/>
            <p:nvPr/>
          </p:nvSpPr>
          <p:spPr>
            <a:xfrm>
              <a:off x="10313245" y="1526889"/>
              <a:ext cx="281353" cy="369332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it-IT" dirty="0">
                  <a:ea typeface="Calibri"/>
                  <a:cs typeface="Calibri"/>
                </a:rPr>
                <a:t>*</a:t>
              </a:r>
              <a:endParaRPr lang="it-IT" dirty="0"/>
            </a:p>
          </p:txBody>
        </p:sp>
        <p:sp>
          <p:nvSpPr>
            <p:cNvPr id="3" name="CasellaDiTesto 1">
              <a:extLst>
                <a:ext uri="{FF2B5EF4-FFF2-40B4-BE49-F238E27FC236}">
                  <a16:creationId xmlns:a16="http://schemas.microsoft.com/office/drawing/2014/main" id="{22D0B2AF-2A18-0BBF-9DE1-9B6449B1BFFA}"/>
                </a:ext>
              </a:extLst>
            </p:cNvPr>
            <p:cNvSpPr txBox="1"/>
            <p:nvPr/>
          </p:nvSpPr>
          <p:spPr>
            <a:xfrm>
              <a:off x="10534274" y="1708840"/>
              <a:ext cx="281353" cy="369332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it-IT" dirty="0">
                  <a:ea typeface="Calibri"/>
                  <a:cs typeface="Calibri"/>
                </a:rPr>
                <a:t>*</a:t>
              </a:r>
              <a:endParaRPr lang="it-IT" dirty="0"/>
            </a:p>
          </p:txBody>
        </p:sp>
        <p:sp>
          <p:nvSpPr>
            <p:cNvPr id="5" name="CasellaDiTesto 1">
              <a:extLst>
                <a:ext uri="{FF2B5EF4-FFF2-40B4-BE49-F238E27FC236}">
                  <a16:creationId xmlns:a16="http://schemas.microsoft.com/office/drawing/2014/main" id="{22D0B2AF-2A18-0BBF-9DE1-9B6449B1BFFA}"/>
                </a:ext>
              </a:extLst>
            </p:cNvPr>
            <p:cNvSpPr txBox="1"/>
            <p:nvPr/>
          </p:nvSpPr>
          <p:spPr>
            <a:xfrm>
              <a:off x="2969226" y="4157254"/>
              <a:ext cx="281353" cy="369332"/>
            </a:xfrm>
            <a:prstGeom prst="rect">
              <a:avLst/>
            </a:prstGeom>
            <a:noFill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>
              <a:defPPr>
                <a:defRPr lang="it-IT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it-IT" dirty="0">
                  <a:ea typeface="Calibri"/>
                  <a:cs typeface="Calibri"/>
                </a:rPr>
                <a:t>*</a:t>
              </a:r>
              <a:endParaRPr lang="it-IT" dirty="0"/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E372BB53-2739-F2D5-5FA2-CB9E86FCFF37}"/>
                </a:ext>
              </a:extLst>
            </p:cNvPr>
            <p:cNvSpPr txBox="1"/>
            <p:nvPr/>
          </p:nvSpPr>
          <p:spPr>
            <a:xfrm>
              <a:off x="1032589" y="1013903"/>
              <a:ext cx="433872" cy="38318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900" dirty="0"/>
                <a:t>0.25</a:t>
              </a:r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r>
                <a:rPr lang="it-IT" sz="900" dirty="0"/>
                <a:t>0.2</a:t>
              </a:r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r>
                <a:rPr lang="it-IT" sz="900" dirty="0"/>
                <a:t>0.15</a:t>
              </a:r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r>
                <a:rPr lang="it-IT" sz="900" dirty="0"/>
                <a:t>0.1</a:t>
              </a:r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r>
                <a:rPr lang="it-IT" sz="900" dirty="0"/>
                <a:t>0.05</a:t>
              </a:r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endParaRPr lang="it-IT" sz="900" dirty="0"/>
            </a:p>
            <a:p>
              <a:r>
                <a:rPr lang="it-IT" sz="900" dirty="0"/>
                <a:t>0</a:t>
              </a:r>
            </a:p>
          </p:txBody>
        </p:sp>
      </p:grp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9245A51-521C-0D9C-B711-6151A16E1172}"/>
              </a:ext>
            </a:extLst>
          </p:cNvPr>
          <p:cNvSpPr txBox="1"/>
          <p:nvPr/>
        </p:nvSpPr>
        <p:spPr>
          <a:xfrm>
            <a:off x="765110" y="74644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700547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o 8">
            <a:extLst>
              <a:ext uri="{FF2B5EF4-FFF2-40B4-BE49-F238E27FC236}">
                <a16:creationId xmlns:a16="http://schemas.microsoft.com/office/drawing/2014/main" id="{E28F7EEC-5A64-A124-6B78-30BEB90942A2}"/>
              </a:ext>
            </a:extLst>
          </p:cNvPr>
          <p:cNvGrpSpPr/>
          <p:nvPr/>
        </p:nvGrpSpPr>
        <p:grpSpPr>
          <a:xfrm>
            <a:off x="681696" y="1103243"/>
            <a:ext cx="10580353" cy="4317843"/>
            <a:chOff x="681696" y="1103243"/>
            <a:chExt cx="10580353" cy="4317843"/>
          </a:xfrm>
        </p:grpSpPr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B1CAE8B3-459C-D423-F012-A2C514E017CB}"/>
                </a:ext>
              </a:extLst>
            </p:cNvPr>
            <p:cNvGrpSpPr/>
            <p:nvPr/>
          </p:nvGrpSpPr>
          <p:grpSpPr>
            <a:xfrm>
              <a:off x="785191" y="1103243"/>
              <a:ext cx="10476858" cy="4317843"/>
              <a:chOff x="1073018" y="1634606"/>
              <a:chExt cx="10189031" cy="3786480"/>
            </a:xfrm>
          </p:grpSpPr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A465BA68-71E3-8C3D-E16B-560F570CA691}"/>
                  </a:ext>
                </a:extLst>
              </p:cNvPr>
              <p:cNvSpPr txBox="1"/>
              <p:nvPr/>
            </p:nvSpPr>
            <p:spPr>
              <a:xfrm>
                <a:off x="8856498" y="2966281"/>
                <a:ext cx="425450" cy="369332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it-IT" dirty="0">
                    <a:ea typeface="Calibri"/>
                    <a:cs typeface="Calibri"/>
                  </a:rPr>
                  <a:t>*</a:t>
                </a:r>
                <a:endParaRPr lang="it-IT" dirty="0"/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86B7AFCE-7677-DC60-77D3-BF27BCAB80D3}"/>
                  </a:ext>
                </a:extLst>
              </p:cNvPr>
              <p:cNvSpPr txBox="1"/>
              <p:nvPr/>
            </p:nvSpPr>
            <p:spPr>
              <a:xfrm>
                <a:off x="4134992" y="2460482"/>
                <a:ext cx="425450" cy="369332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it-IT" dirty="0">
                    <a:ea typeface="Calibri"/>
                    <a:cs typeface="Calibri"/>
                  </a:rPr>
                  <a:t>*</a:t>
                </a:r>
                <a:endParaRPr lang="it-IT" dirty="0"/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77127453-F6DF-F859-8AE9-AA8C0BE08233}"/>
                  </a:ext>
                </a:extLst>
              </p:cNvPr>
              <p:cNvSpPr txBox="1"/>
              <p:nvPr/>
            </p:nvSpPr>
            <p:spPr>
              <a:xfrm>
                <a:off x="6593220" y="3617478"/>
                <a:ext cx="425450" cy="369332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it-IT" dirty="0">
                    <a:ea typeface="Calibri"/>
                    <a:cs typeface="Calibri"/>
                  </a:rPr>
                  <a:t>*</a:t>
                </a:r>
                <a:endParaRPr lang="it-IT" dirty="0"/>
              </a:p>
            </p:txBody>
          </p:sp>
          <p:graphicFrame>
            <p:nvGraphicFramePr>
              <p:cNvPr id="3" name="Grafico 2">
                <a:extLst>
                  <a:ext uri="{FF2B5EF4-FFF2-40B4-BE49-F238E27FC236}">
                    <a16:creationId xmlns:a16="http://schemas.microsoft.com/office/drawing/2014/main" id="{5D44C64A-3FFD-7442-E3A5-2ADEEC03452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18225306"/>
                  </p:ext>
                </p:extLst>
              </p:nvPr>
            </p:nvGraphicFramePr>
            <p:xfrm>
              <a:off x="1073018" y="1634606"/>
              <a:ext cx="10189031" cy="37864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</p:grp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299E17BF-CEF3-E0C4-6CA3-1E5927C7AE00}"/>
                </a:ext>
              </a:extLst>
            </p:cNvPr>
            <p:cNvSpPr txBox="1"/>
            <p:nvPr/>
          </p:nvSpPr>
          <p:spPr>
            <a:xfrm>
              <a:off x="681696" y="1702381"/>
              <a:ext cx="413896" cy="332398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5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45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4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35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3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25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2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15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1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.05</a:t>
              </a:r>
            </a:p>
            <a:p>
              <a:endParaRPr lang="it-IT" sz="1000" dirty="0">
                <a:solidFill>
                  <a:schemeClr val="bg1">
                    <a:lumMod val="50000"/>
                  </a:schemeClr>
                </a:solidFill>
              </a:endParaRPr>
            </a:p>
            <a:p>
              <a:r>
                <a:rPr lang="it-IT" sz="1000" dirty="0">
                  <a:solidFill>
                    <a:schemeClr val="bg1">
                      <a:lumMod val="50000"/>
                    </a:schemeClr>
                  </a:solidFill>
                </a:rPr>
                <a:t>0</a:t>
              </a: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EAFDF4E-1465-12A0-1377-8182F565FA33}"/>
              </a:ext>
            </a:extLst>
          </p:cNvPr>
          <p:cNvSpPr txBox="1"/>
          <p:nvPr/>
        </p:nvSpPr>
        <p:spPr>
          <a:xfrm>
            <a:off x="765110" y="746449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00801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CB3B312D-35DB-8DC2-B204-5DBA7ACEEB26}"/>
              </a:ext>
            </a:extLst>
          </p:cNvPr>
          <p:cNvGraphicFramePr>
            <a:graphicFrameLocks/>
          </p:cNvGraphicFramePr>
          <p:nvPr/>
        </p:nvGraphicFramePr>
        <p:xfrm>
          <a:off x="1399592" y="774441"/>
          <a:ext cx="9053143" cy="48434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467388A8-195A-D52C-2A73-648FC558FB1A}"/>
              </a:ext>
            </a:extLst>
          </p:cNvPr>
          <p:cNvSpPr txBox="1"/>
          <p:nvPr/>
        </p:nvSpPr>
        <p:spPr>
          <a:xfrm>
            <a:off x="6096000" y="43853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*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ABBE8D0A-352D-782E-93B1-BD1EA9702869}"/>
              </a:ext>
            </a:extLst>
          </p:cNvPr>
          <p:cNvSpPr txBox="1"/>
          <p:nvPr/>
        </p:nvSpPr>
        <p:spPr>
          <a:xfrm>
            <a:off x="8263812" y="226111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*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429D9AE-1AA1-3A4B-1DF1-D24FC6E4A633}"/>
              </a:ext>
            </a:extLst>
          </p:cNvPr>
          <p:cNvSpPr txBox="1"/>
          <p:nvPr/>
        </p:nvSpPr>
        <p:spPr>
          <a:xfrm>
            <a:off x="8455788" y="34290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*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11819432-E7A1-C546-C7B5-D9610B64D055}"/>
              </a:ext>
            </a:extLst>
          </p:cNvPr>
          <p:cNvSpPr txBox="1"/>
          <p:nvPr/>
        </p:nvSpPr>
        <p:spPr>
          <a:xfrm>
            <a:off x="765110" y="74644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840208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o 6">
            <a:extLst>
              <a:ext uri="{FF2B5EF4-FFF2-40B4-BE49-F238E27FC236}">
                <a16:creationId xmlns:a16="http://schemas.microsoft.com/office/drawing/2014/main" id="{23960F39-098B-9A84-B6CA-E88CA04D74B6}"/>
              </a:ext>
            </a:extLst>
          </p:cNvPr>
          <p:cNvGrpSpPr/>
          <p:nvPr/>
        </p:nvGrpSpPr>
        <p:grpSpPr>
          <a:xfrm>
            <a:off x="1060695" y="1258815"/>
            <a:ext cx="9902774" cy="3964836"/>
            <a:chOff x="1060695" y="1258815"/>
            <a:chExt cx="9902774" cy="3964836"/>
          </a:xfrm>
        </p:grpSpPr>
        <p:graphicFrame>
          <p:nvGraphicFramePr>
            <p:cNvPr id="4" name="Grafico 3">
              <a:extLst>
                <a:ext uri="{FF2B5EF4-FFF2-40B4-BE49-F238E27FC236}">
                  <a16:creationId xmlns:a16="http://schemas.microsoft.com/office/drawing/2014/main" id="{29D77426-4FC1-155B-1D7D-3DC2B8D48A4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060695" y="1258815"/>
            <a:ext cx="9902774" cy="39648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71FCD82E-0D40-1898-A99E-40C1944DD54B}"/>
                </a:ext>
              </a:extLst>
            </p:cNvPr>
            <p:cNvGrpSpPr/>
            <p:nvPr/>
          </p:nvGrpSpPr>
          <p:grpSpPr>
            <a:xfrm>
              <a:off x="3856462" y="2077432"/>
              <a:ext cx="6334370" cy="2227456"/>
              <a:chOff x="3856462" y="2077432"/>
              <a:chExt cx="6334370" cy="2227456"/>
            </a:xfrm>
          </p:grpSpPr>
          <p:sp>
            <p:nvSpPr>
              <p:cNvPr id="2" name="CasellaDiTesto 1">
                <a:extLst>
                  <a:ext uri="{FF2B5EF4-FFF2-40B4-BE49-F238E27FC236}">
                    <a16:creationId xmlns:a16="http://schemas.microsoft.com/office/drawing/2014/main" id="{22D0B2AF-2A18-0BBF-9DE1-9B6449B1BFFA}"/>
                  </a:ext>
                </a:extLst>
              </p:cNvPr>
              <p:cNvSpPr txBox="1"/>
              <p:nvPr/>
            </p:nvSpPr>
            <p:spPr>
              <a:xfrm>
                <a:off x="4727624" y="2077432"/>
                <a:ext cx="281353" cy="369332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it-IT" dirty="0">
                    <a:ea typeface="Calibri"/>
                    <a:cs typeface="Calibri"/>
                  </a:rPr>
                  <a:t>*</a:t>
                </a:r>
                <a:endParaRPr lang="it-IT" dirty="0"/>
              </a:p>
            </p:txBody>
          </p:sp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5C42E69D-5055-4C44-3546-103A3CBF2F49}"/>
                  </a:ext>
                </a:extLst>
              </p:cNvPr>
              <p:cNvSpPr txBox="1"/>
              <p:nvPr/>
            </p:nvSpPr>
            <p:spPr>
              <a:xfrm>
                <a:off x="9909479" y="2158684"/>
                <a:ext cx="281353" cy="369332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it-IT" dirty="0">
                    <a:ea typeface="Calibri"/>
                    <a:cs typeface="Calibri"/>
                  </a:rPr>
                  <a:t>*</a:t>
                </a:r>
                <a:endParaRPr lang="it-IT" dirty="0"/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8DDC80AA-6888-3266-ABF7-6835896B001F}"/>
                  </a:ext>
                </a:extLst>
              </p:cNvPr>
              <p:cNvSpPr txBox="1"/>
              <p:nvPr/>
            </p:nvSpPr>
            <p:spPr>
              <a:xfrm>
                <a:off x="3856462" y="3935556"/>
                <a:ext cx="281353" cy="369332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it-IT" dirty="0">
                    <a:ea typeface="Calibri"/>
                    <a:cs typeface="Calibri"/>
                  </a:rPr>
                  <a:t>*</a:t>
                </a:r>
                <a:endParaRPr lang="it-IT" dirty="0"/>
              </a:p>
            </p:txBody>
          </p:sp>
        </p:grpSp>
      </p:grp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07668CF-B08B-6C0D-7B4E-38EB1E0C0298}"/>
              </a:ext>
            </a:extLst>
          </p:cNvPr>
          <p:cNvSpPr txBox="1"/>
          <p:nvPr/>
        </p:nvSpPr>
        <p:spPr>
          <a:xfrm>
            <a:off x="765110" y="74644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/>
              <a:t>e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7940234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6AAD567F-06D1-56E2-F8C8-87065E9386A5}"/>
              </a:ext>
            </a:extLst>
          </p:cNvPr>
          <p:cNvSpPr txBox="1"/>
          <p:nvPr/>
        </p:nvSpPr>
        <p:spPr>
          <a:xfrm>
            <a:off x="770297" y="5282569"/>
            <a:ext cx="6096000" cy="15754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2   </a:t>
            </a:r>
            <a:endParaRPr lang="en-US" sz="1800" b="1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CR conditions:</a:t>
            </a:r>
            <a:endParaRPr lang="it-IT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it-IT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, </a:t>
            </a:r>
            <a:r>
              <a:rPr lang="it-IT" sz="1800" b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enaturation</a:t>
            </a:r>
            <a:r>
              <a:rPr lang="it-IT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; A, </a:t>
            </a:r>
            <a:r>
              <a:rPr lang="it-IT" sz="1800" b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nealing</a:t>
            </a:r>
            <a:r>
              <a:rPr lang="it-IT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; E, extension</a:t>
            </a:r>
            <a:endParaRPr lang="it-IT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it-IT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Tabella 9">
            <a:extLst>
              <a:ext uri="{FF2B5EF4-FFF2-40B4-BE49-F238E27FC236}">
                <a16:creationId xmlns:a16="http://schemas.microsoft.com/office/drawing/2014/main" id="{0C0F805C-C72D-CB44-06F5-7406B8FF3F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9613793"/>
              </p:ext>
            </p:extLst>
          </p:nvPr>
        </p:nvGraphicFramePr>
        <p:xfrm>
          <a:off x="851358" y="500491"/>
          <a:ext cx="3640361" cy="4639670"/>
        </p:xfrm>
        <a:graphic>
          <a:graphicData uri="http://schemas.openxmlformats.org/drawingml/2006/table">
            <a:tbl>
              <a:tblPr firstRow="1" firstCol="1" bandRow="1"/>
              <a:tblGrid>
                <a:gridCol w="612026">
                  <a:extLst>
                    <a:ext uri="{9D8B030D-6E8A-4147-A177-3AD203B41FA5}">
                      <a16:colId xmlns:a16="http://schemas.microsoft.com/office/drawing/2014/main" val="3427290020"/>
                    </a:ext>
                  </a:extLst>
                </a:gridCol>
                <a:gridCol w="3028335">
                  <a:extLst>
                    <a:ext uri="{9D8B030D-6E8A-4147-A177-3AD203B41FA5}">
                      <a16:colId xmlns:a16="http://schemas.microsoft.com/office/drawing/2014/main" val="3696653253"/>
                    </a:ext>
                  </a:extLst>
                </a:gridCol>
              </a:tblGrid>
              <a:tr h="16082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CR CYCLE 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5922854"/>
                  </a:ext>
                </a:extLst>
              </a:tr>
              <a:tr h="70142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13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: 94 °C 5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: 94 °C 1 min; A: 45 °C 1 min; E: 72 °C 2 min)</a:t>
                      </a:r>
                      <a:r>
                        <a:rPr lang="it-IT" sz="1000" b="1" kern="100" baseline="-250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0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: 72 °C 10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9032470"/>
                  </a:ext>
                </a:extLst>
              </a:tr>
              <a:tr h="70142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14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: 94 °C 5 min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: 94 °C 1 min; A: 45 °C 1 min; E: 72 °C 2 min)</a:t>
                      </a:r>
                      <a:r>
                        <a:rPr lang="it-IT" sz="1000" b="1" kern="100" baseline="-250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0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: 72 °C 10 min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509644"/>
                  </a:ext>
                </a:extLst>
              </a:tr>
              <a:tr h="70142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IR 1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: 94 °C 5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: 94 °C 1 min; A: 54.4 °C 1 min; E: 72 °C 1 min)</a:t>
                      </a:r>
                      <a:r>
                        <a:rPr lang="it-IT" sz="1000" b="1" kern="100" baseline="-250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: 72 °C 7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4562442"/>
                  </a:ext>
                </a:extLst>
              </a:tr>
              <a:tr h="70142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PIR 3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: 94 °C 5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: 94 °C 1 min; A: 56.5 °C 1 min; E: 72 °C 2 min)</a:t>
                      </a:r>
                      <a:r>
                        <a:rPr lang="it-IT" sz="1000" b="1" kern="100" baseline="-250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: 72 °C 7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7790747"/>
                  </a:ext>
                </a:extLst>
              </a:tr>
              <a:tr h="70142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PK03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: 94 °C 5 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: 94 °C 1 min; A: 36 °C 1 min; E: 72 °C 2 min)</a:t>
                      </a:r>
                      <a:r>
                        <a:rPr lang="it-IT" sz="1000" b="1" kern="100" baseline="-250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0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: 72 °C 10min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9009777"/>
                  </a:ext>
                </a:extLst>
              </a:tr>
              <a:tr h="97172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OPC20</a:t>
                      </a:r>
                      <a:endParaRPr lang="it-IT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: 94 °C 2 min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(D: 94 °C 1 min; A: 35 °C 1 min; E: 72 °C 2 min)</a:t>
                      </a:r>
                      <a:r>
                        <a:rPr lang="it-IT" sz="1000" b="1" kern="100" baseline="-250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E: 72 °C 10 min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it-IT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334" marR="6133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75813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627043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FB2E7670-4C7A-A755-DF56-A99530D743F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5794" t="30004" r="133"/>
          <a:stretch/>
        </p:blipFill>
        <p:spPr>
          <a:xfrm>
            <a:off x="580103" y="1316655"/>
            <a:ext cx="3978473" cy="2793229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8EDD95C6-A69B-DEC8-1929-F4C553405835}"/>
              </a:ext>
            </a:extLst>
          </p:cNvPr>
          <p:cNvSpPr txBox="1"/>
          <p:nvPr/>
        </p:nvSpPr>
        <p:spPr>
          <a:xfrm>
            <a:off x="1002890" y="609600"/>
            <a:ext cx="1487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PRIMER M14</a:t>
            </a:r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B3BE73C3-776B-2BAD-5490-BBEA768BD29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0896" t="27357"/>
          <a:stretch/>
        </p:blipFill>
        <p:spPr>
          <a:xfrm>
            <a:off x="5604386" y="1101213"/>
            <a:ext cx="3978473" cy="325447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3791623C-65C6-63EF-8ED4-8795A8CF68C0}"/>
              </a:ext>
            </a:extLst>
          </p:cNvPr>
          <p:cNvSpPr txBox="1"/>
          <p:nvPr/>
        </p:nvSpPr>
        <p:spPr>
          <a:xfrm>
            <a:off x="5604386" y="449515"/>
            <a:ext cx="1487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PRIMER M13</a:t>
            </a:r>
          </a:p>
        </p:txBody>
      </p:sp>
    </p:spTree>
    <p:extLst>
      <p:ext uri="{BB962C8B-B14F-4D97-AF65-F5344CB8AC3E}">
        <p14:creationId xmlns:p14="http://schemas.microsoft.com/office/powerpoint/2010/main" val="20822421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magine 10">
            <a:extLst>
              <a:ext uri="{FF2B5EF4-FFF2-40B4-BE49-F238E27FC236}">
                <a16:creationId xmlns:a16="http://schemas.microsoft.com/office/drawing/2014/main" id="{A7E11245-896D-81DD-C5AC-73FC7FB9447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-1" t="23627" r="-3095"/>
          <a:stretch/>
        </p:blipFill>
        <p:spPr>
          <a:xfrm>
            <a:off x="0" y="1022556"/>
            <a:ext cx="4781647" cy="3303638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80B9CAD-61A9-2F1A-03FA-923CFCFD9042}"/>
              </a:ext>
            </a:extLst>
          </p:cNvPr>
          <p:cNvSpPr txBox="1"/>
          <p:nvPr/>
        </p:nvSpPr>
        <p:spPr>
          <a:xfrm>
            <a:off x="1071715" y="609600"/>
            <a:ext cx="1574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PRIMER PIR 1</a:t>
            </a:r>
          </a:p>
        </p:txBody>
      </p: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918F1627-F9C3-DA8F-9317-751F3EE96BF5}"/>
              </a:ext>
            </a:extLst>
          </p:cNvPr>
          <p:cNvGrpSpPr/>
          <p:nvPr/>
        </p:nvGrpSpPr>
        <p:grpSpPr>
          <a:xfrm>
            <a:off x="4657985" y="978932"/>
            <a:ext cx="7052234" cy="3578942"/>
            <a:chOff x="5394421" y="1387677"/>
            <a:chExt cx="8526020" cy="4182297"/>
          </a:xfrm>
        </p:grpSpPr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463E0AC8-3CE0-44B4-2204-84F1BDCA59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grayscl/>
            </a:blip>
            <a:stretch>
              <a:fillRect/>
            </a:stretch>
          </p:blipFill>
          <p:spPr>
            <a:xfrm>
              <a:off x="6607276" y="1871083"/>
              <a:ext cx="7313165" cy="3698891"/>
            </a:xfrm>
            <a:prstGeom prst="rect">
              <a:avLst/>
            </a:prstGeom>
          </p:spPr>
        </p:pic>
        <p:pic>
          <p:nvPicPr>
            <p:cNvPr id="18" name="Immagine 17">
              <a:extLst>
                <a:ext uri="{FF2B5EF4-FFF2-40B4-BE49-F238E27FC236}">
                  <a16:creationId xmlns:a16="http://schemas.microsoft.com/office/drawing/2014/main" id="{53F81743-8DDE-6BC3-BCAF-F1BA49E5DDC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394421" y="2589046"/>
              <a:ext cx="1157174" cy="2262963"/>
            </a:xfrm>
            <a:prstGeom prst="rect">
              <a:avLst/>
            </a:prstGeom>
          </p:spPr>
        </p:pic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E2E062A8-F2E4-EEBE-6F41-B95A6ACAB038}"/>
                </a:ext>
              </a:extLst>
            </p:cNvPr>
            <p:cNvSpPr txBox="1"/>
            <p:nvPr/>
          </p:nvSpPr>
          <p:spPr>
            <a:xfrm>
              <a:off x="6500602" y="1387677"/>
              <a:ext cx="14300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M1kb</a:t>
              </a:r>
            </a:p>
          </p:txBody>
        </p:sp>
      </p:grp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F9C6DD21-CBC8-D1DC-28D7-209C421EC2C8}"/>
              </a:ext>
            </a:extLst>
          </p:cNvPr>
          <p:cNvSpPr txBox="1"/>
          <p:nvPr/>
        </p:nvSpPr>
        <p:spPr>
          <a:xfrm>
            <a:off x="5615133" y="482508"/>
            <a:ext cx="1527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PRIMER PIR3</a:t>
            </a:r>
          </a:p>
        </p:txBody>
      </p:sp>
    </p:spTree>
    <p:extLst>
      <p:ext uri="{BB962C8B-B14F-4D97-AF65-F5344CB8AC3E}">
        <p14:creationId xmlns:p14="http://schemas.microsoft.com/office/powerpoint/2010/main" val="41391587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B9A9E0B3-C5D2-4C0E-6A10-0E6C9420008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25033"/>
          <a:stretch/>
        </p:blipFill>
        <p:spPr>
          <a:xfrm>
            <a:off x="-366743" y="1288026"/>
            <a:ext cx="4375799" cy="3578942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7017A296-2B54-9356-5D05-51BF26E7CB2F}"/>
              </a:ext>
            </a:extLst>
          </p:cNvPr>
          <p:cNvSpPr txBox="1"/>
          <p:nvPr/>
        </p:nvSpPr>
        <p:spPr>
          <a:xfrm>
            <a:off x="1032386" y="678425"/>
            <a:ext cx="1771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PRIMER OPC20</a:t>
            </a:r>
          </a:p>
        </p:txBody>
      </p:sp>
      <p:pic>
        <p:nvPicPr>
          <p:cNvPr id="12" name="Immagine 11">
            <a:extLst>
              <a:ext uri="{FF2B5EF4-FFF2-40B4-BE49-F238E27FC236}">
                <a16:creationId xmlns:a16="http://schemas.microsoft.com/office/drawing/2014/main" id="{B7DC5E22-27B8-9E58-07FA-F86756D9549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9446" r="13933"/>
          <a:stretch/>
        </p:blipFill>
        <p:spPr>
          <a:xfrm>
            <a:off x="5928450" y="1402266"/>
            <a:ext cx="4769047" cy="3643704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15E32E8-C480-16B0-F723-7CD4D9952AD9}"/>
              </a:ext>
            </a:extLst>
          </p:cNvPr>
          <p:cNvSpPr txBox="1"/>
          <p:nvPr/>
        </p:nvSpPr>
        <p:spPr>
          <a:xfrm>
            <a:off x="6661354" y="757084"/>
            <a:ext cx="1752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PRIMER OPK03</a:t>
            </a:r>
          </a:p>
        </p:txBody>
      </p:sp>
    </p:spTree>
    <p:extLst>
      <p:ext uri="{BB962C8B-B14F-4D97-AF65-F5344CB8AC3E}">
        <p14:creationId xmlns:p14="http://schemas.microsoft.com/office/powerpoint/2010/main" val="37644730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0B03F3596E54C6449B99645ECA731027" ma:contentTypeVersion="4" ma:contentTypeDescription="Creare un nuovo documento." ma:contentTypeScope="" ma:versionID="538ca16899d5d15aa0c8d618be6ae447">
  <xsd:schema xmlns:xsd="http://www.w3.org/2001/XMLSchema" xmlns:xs="http://www.w3.org/2001/XMLSchema" xmlns:p="http://schemas.microsoft.com/office/2006/metadata/properties" xmlns:ns2="fa4961f6-77d4-4ff6-aabb-715696b596f7" targetNamespace="http://schemas.microsoft.com/office/2006/metadata/properties" ma:root="true" ma:fieldsID="2760a46269e78b8ab37651aed3864eb9" ns2:_="">
    <xsd:import namespace="fa4961f6-77d4-4ff6-aabb-715696b596f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a4961f6-77d4-4ff6-aabb-715696b596f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89FE27A-8C82-4758-8882-B806FFF9941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a4961f6-77d4-4ff6-aabb-715696b596f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1BB4C51-1FBF-49DE-ABDD-D188F280C705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0501C903-3B2B-4206-A6BA-FF6E4168AD1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387</Words>
  <Application>Microsoft Office PowerPoint</Application>
  <PresentationFormat>Widescreen</PresentationFormat>
  <Paragraphs>115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ptos</vt:lpstr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URA CANONICO</dc:creator>
  <cp:lastModifiedBy>MDPI</cp:lastModifiedBy>
  <cp:revision>15</cp:revision>
  <dcterms:created xsi:type="dcterms:W3CDTF">2024-02-21T12:42:34Z</dcterms:created>
  <dcterms:modified xsi:type="dcterms:W3CDTF">2024-10-31T01:55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B03F3596E54C6449B99645ECA731027</vt:lpwstr>
  </property>
</Properties>
</file>